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 snapToGrid="0">
      <p:cViewPr varScale="1">
        <p:scale>
          <a:sx n="74" d="100"/>
          <a:sy n="74" d="100"/>
        </p:scale>
        <p:origin x="2179" y="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住吉 秀太郎" userId="f57d79c7034a3c66" providerId="LiveId" clId="{2B9CF233-1324-4502-BEB2-A671B0089D2D}"/>
    <pc:docChg chg="undo custSel addSld modSld">
      <pc:chgData name="住吉 秀太郎" userId="f57d79c7034a3c66" providerId="LiveId" clId="{2B9CF233-1324-4502-BEB2-A671B0089D2D}" dt="2021-09-22T08:53:59.863" v="21" actId="1076"/>
      <pc:docMkLst>
        <pc:docMk/>
      </pc:docMkLst>
      <pc:sldChg chg="modSp mod">
        <pc:chgData name="住吉 秀太郎" userId="f57d79c7034a3c66" providerId="LiveId" clId="{2B9CF233-1324-4502-BEB2-A671B0089D2D}" dt="2021-09-22T08:53:59.863" v="21" actId="1076"/>
        <pc:sldMkLst>
          <pc:docMk/>
          <pc:sldMk cId="2536174185" sldId="256"/>
        </pc:sldMkLst>
        <pc:spChg chg="mod">
          <ac:chgData name="住吉 秀太郎" userId="f57d79c7034a3c66" providerId="LiveId" clId="{2B9CF233-1324-4502-BEB2-A671B0089D2D}" dt="2021-09-22T08:53:59.863" v="21" actId="1076"/>
          <ac:spMkLst>
            <pc:docMk/>
            <pc:sldMk cId="2536174185" sldId="256"/>
            <ac:spMk id="6" creationId="{619AFC5E-F95A-425F-A5E7-68064136FD1E}"/>
          </ac:spMkLst>
        </pc:spChg>
      </pc:sldChg>
      <pc:sldChg chg="addSp delSp modSp new mod">
        <pc:chgData name="住吉 秀太郎" userId="f57d79c7034a3c66" providerId="LiveId" clId="{2B9CF233-1324-4502-BEB2-A671B0089D2D}" dt="2021-09-22T08:52:52.435" v="15" actId="1076"/>
        <pc:sldMkLst>
          <pc:docMk/>
          <pc:sldMk cId="457187030" sldId="257"/>
        </pc:sldMkLst>
        <pc:spChg chg="del">
          <ac:chgData name="住吉 秀太郎" userId="f57d79c7034a3c66" providerId="LiveId" clId="{2B9CF233-1324-4502-BEB2-A671B0089D2D}" dt="2021-09-22T08:52:09.004" v="2" actId="478"/>
          <ac:spMkLst>
            <pc:docMk/>
            <pc:sldMk cId="457187030" sldId="257"/>
            <ac:spMk id="2" creationId="{7E985031-9611-4D5D-8879-5AFB9B8DB820}"/>
          </ac:spMkLst>
        </pc:spChg>
        <pc:spChg chg="del">
          <ac:chgData name="住吉 秀太郎" userId="f57d79c7034a3c66" providerId="LiveId" clId="{2B9CF233-1324-4502-BEB2-A671B0089D2D}" dt="2021-09-22T08:52:07.466" v="1" actId="478"/>
          <ac:spMkLst>
            <pc:docMk/>
            <pc:sldMk cId="457187030" sldId="257"/>
            <ac:spMk id="3" creationId="{5F5050BC-82F5-4780-B3B3-7B2C90476CD7}"/>
          </ac:spMkLst>
        </pc:spChg>
        <pc:spChg chg="add mod">
          <ac:chgData name="住吉 秀太郎" userId="f57d79c7034a3c66" providerId="LiveId" clId="{2B9CF233-1324-4502-BEB2-A671B0089D2D}" dt="2021-09-22T08:52:52.435" v="15" actId="1076"/>
          <ac:spMkLst>
            <pc:docMk/>
            <pc:sldMk cId="457187030" sldId="257"/>
            <ac:spMk id="5" creationId="{1A3A6331-3214-4D25-848B-9DEA7984DEB8}"/>
          </ac:spMkLst>
        </pc:spChg>
        <pc:picChg chg="add mod">
          <ac:chgData name="住吉 秀太郎" userId="f57d79c7034a3c66" providerId="LiveId" clId="{2B9CF233-1324-4502-BEB2-A671B0089D2D}" dt="2021-09-22T08:52:49.473" v="14" actId="1076"/>
          <ac:picMkLst>
            <pc:docMk/>
            <pc:sldMk cId="457187030" sldId="257"/>
            <ac:picMk id="4" creationId="{FC2F9F33-26FD-4C01-8639-1953EAC271A0}"/>
          </ac:picMkLst>
        </pc:picChg>
      </pc:sldChg>
    </pc:docChg>
  </pc:docChgLst>
  <pc:docChgLst>
    <pc:chgData name="住吉 秀太郎" userId="f57d79c7034a3c66" providerId="LiveId" clId="{AF8CDAF2-65FF-46B6-A21D-0AB0513C72FB}"/>
    <pc:docChg chg="delSld">
      <pc:chgData name="住吉 秀太郎" userId="f57d79c7034a3c66" providerId="LiveId" clId="{AF8CDAF2-65FF-46B6-A21D-0AB0513C72FB}" dt="2021-09-24T12:13:10.723" v="0" actId="47"/>
      <pc:docMkLst>
        <pc:docMk/>
      </pc:docMkLst>
      <pc:sldChg chg="del">
        <pc:chgData name="住吉 秀太郎" userId="f57d79c7034a3c66" providerId="LiveId" clId="{AF8CDAF2-65FF-46B6-A21D-0AB0513C72FB}" dt="2021-09-24T12:13:10.723" v="0" actId="47"/>
        <pc:sldMkLst>
          <pc:docMk/>
          <pc:sldMk cId="457187030" sldId="257"/>
        </pc:sldMkLst>
      </pc:sldChg>
    </pc:docChg>
  </pc:docChgLst>
  <pc:docChgLst>
    <pc:chgData name="住吉 秀太郎" userId="f57d79c7034a3c66" providerId="LiveId" clId="{61177385-A7F3-44AF-A277-41A4C5542880}"/>
    <pc:docChg chg="modSld">
      <pc:chgData name="住吉 秀太郎" userId="f57d79c7034a3c66" providerId="LiveId" clId="{61177385-A7F3-44AF-A277-41A4C5542880}" dt="2022-04-28T00:18:20.411" v="9" actId="1076"/>
      <pc:docMkLst>
        <pc:docMk/>
      </pc:docMkLst>
      <pc:sldChg chg="addSp modSp mod">
        <pc:chgData name="住吉 秀太郎" userId="f57d79c7034a3c66" providerId="LiveId" clId="{61177385-A7F3-44AF-A277-41A4C5542880}" dt="2022-04-28T00:18:20.411" v="9" actId="1076"/>
        <pc:sldMkLst>
          <pc:docMk/>
          <pc:sldMk cId="2536174185" sldId="256"/>
        </pc:sldMkLst>
        <pc:spChg chg="add mod">
          <ac:chgData name="住吉 秀太郎" userId="f57d79c7034a3c66" providerId="LiveId" clId="{61177385-A7F3-44AF-A277-41A4C5542880}" dt="2022-04-28T00:18:20.411" v="9" actId="1076"/>
          <ac:spMkLst>
            <pc:docMk/>
            <pc:sldMk cId="2536174185" sldId="256"/>
            <ac:spMk id="40" creationId="{3A3D43A9-F202-420F-8685-2FABD8FBD900}"/>
          </ac:spMkLst>
        </pc:spChg>
      </pc:sldChg>
    </pc:docChg>
  </pc:docChgLst>
  <pc:docChgLst>
    <pc:chgData name="住吉 秀太郎" userId="f57d79c7034a3c66" providerId="LiveId" clId="{743CD99B-4BC1-4438-8861-7A02D8491949}"/>
    <pc:docChg chg="undo redo custSel addSld delSld modSld">
      <pc:chgData name="住吉 秀太郎" userId="f57d79c7034a3c66" providerId="LiveId" clId="{743CD99B-4BC1-4438-8861-7A02D8491949}" dt="2023-03-18T13:20:26.227" v="784" actId="1036"/>
      <pc:docMkLst>
        <pc:docMk/>
      </pc:docMkLst>
      <pc:sldChg chg="addSp delSp modSp mod">
        <pc:chgData name="住吉 秀太郎" userId="f57d79c7034a3c66" providerId="LiveId" clId="{743CD99B-4BC1-4438-8861-7A02D8491949}" dt="2023-03-16T12:18:28.387" v="160" actId="20577"/>
        <pc:sldMkLst>
          <pc:docMk/>
          <pc:sldMk cId="2536174185" sldId="256"/>
        </pc:sldMkLst>
        <pc:spChg chg="mod">
          <ac:chgData name="住吉 秀太郎" userId="f57d79c7034a3c66" providerId="LiveId" clId="{743CD99B-4BC1-4438-8861-7A02D8491949}" dt="2023-03-16T12:15:02.634" v="104" actId="1076"/>
          <ac:spMkLst>
            <pc:docMk/>
            <pc:sldMk cId="2536174185" sldId="256"/>
            <ac:spMk id="3" creationId="{BAC6F3F3-AF1C-406D-9911-E783711A4A72}"/>
          </ac:spMkLst>
        </pc:spChg>
        <pc:spChg chg="mod">
          <ac:chgData name="住吉 秀太郎" userId="f57d79c7034a3c66" providerId="LiveId" clId="{743CD99B-4BC1-4438-8861-7A02D8491949}" dt="2023-03-16T12:05:29.406" v="12"/>
          <ac:spMkLst>
            <pc:docMk/>
            <pc:sldMk cId="2536174185" sldId="256"/>
            <ac:spMk id="12" creationId="{5BF2B345-8936-3395-7A0A-494ECB499411}"/>
          </ac:spMkLst>
        </pc:spChg>
        <pc:spChg chg="mod">
          <ac:chgData name="住吉 秀太郎" userId="f57d79c7034a3c66" providerId="LiveId" clId="{743CD99B-4BC1-4438-8861-7A02D8491949}" dt="2023-03-16T12:05:29.406" v="12"/>
          <ac:spMkLst>
            <pc:docMk/>
            <pc:sldMk cId="2536174185" sldId="256"/>
            <ac:spMk id="14" creationId="{7E765BFA-8CA1-4CB7-C45F-1ED89FA39B8A}"/>
          </ac:spMkLst>
        </pc:spChg>
        <pc:spChg chg="mod">
          <ac:chgData name="住吉 秀太郎" userId="f57d79c7034a3c66" providerId="LiveId" clId="{743CD99B-4BC1-4438-8861-7A02D8491949}" dt="2023-03-16T12:17:36.560" v="139" actId="1076"/>
          <ac:spMkLst>
            <pc:docMk/>
            <pc:sldMk cId="2536174185" sldId="256"/>
            <ac:spMk id="16" creationId="{0F5026B1-FD8E-41AF-9578-F97F634F023E}"/>
          </ac:spMkLst>
        </pc:spChg>
        <pc:spChg chg="mod">
          <ac:chgData name="住吉 秀太郎" userId="f57d79c7034a3c66" providerId="LiveId" clId="{743CD99B-4BC1-4438-8861-7A02D8491949}" dt="2023-03-16T12:18:23.609" v="155" actId="20577"/>
          <ac:spMkLst>
            <pc:docMk/>
            <pc:sldMk cId="2536174185" sldId="256"/>
            <ac:spMk id="17" creationId="{4FD45669-2DC7-48FE-B789-263EDE7352E6}"/>
          </ac:spMkLst>
        </pc:spChg>
        <pc:spChg chg="mod">
          <ac:chgData name="住吉 秀太郎" userId="f57d79c7034a3c66" providerId="LiveId" clId="{743CD99B-4BC1-4438-8861-7A02D8491949}" dt="2023-03-16T12:17:51.014" v="150" actId="20577"/>
          <ac:spMkLst>
            <pc:docMk/>
            <pc:sldMk cId="2536174185" sldId="256"/>
            <ac:spMk id="18" creationId="{8645A9A0-52E6-4C2D-9FE7-E9156A13A169}"/>
          </ac:spMkLst>
        </pc:spChg>
        <pc:spChg chg="mod">
          <ac:chgData name="住吉 秀太郎" userId="f57d79c7034a3c66" providerId="LiveId" clId="{743CD99B-4BC1-4438-8861-7A02D8491949}" dt="2023-03-16T12:17:47.255" v="144" actId="20577"/>
          <ac:spMkLst>
            <pc:docMk/>
            <pc:sldMk cId="2536174185" sldId="256"/>
            <ac:spMk id="19" creationId="{E8FFE24B-6DEE-4C42-A38D-94F6269A5016}"/>
          </ac:spMkLst>
        </pc:spChg>
        <pc:spChg chg="mod">
          <ac:chgData name="住吉 秀太郎" userId="f57d79c7034a3c66" providerId="LiveId" clId="{743CD99B-4BC1-4438-8861-7A02D8491949}" dt="2023-03-16T12:15:09.099" v="107" actId="403"/>
          <ac:spMkLst>
            <pc:docMk/>
            <pc:sldMk cId="2536174185" sldId="256"/>
            <ac:spMk id="23" creationId="{6F071C56-5DD5-4BBB-B14E-CD2D75B7B478}"/>
          </ac:spMkLst>
        </pc:spChg>
        <pc:spChg chg="mod">
          <ac:chgData name="住吉 秀太郎" userId="f57d79c7034a3c66" providerId="LiveId" clId="{743CD99B-4BC1-4438-8861-7A02D8491949}" dt="2023-03-16T12:15:20.200" v="108" actId="1076"/>
          <ac:spMkLst>
            <pc:docMk/>
            <pc:sldMk cId="2536174185" sldId="256"/>
            <ac:spMk id="25" creationId="{35DFF634-96C1-4056-8171-AC743426A99F}"/>
          </ac:spMkLst>
        </pc:spChg>
        <pc:spChg chg="mod">
          <ac:chgData name="住吉 秀太郎" userId="f57d79c7034a3c66" providerId="LiveId" clId="{743CD99B-4BC1-4438-8861-7A02D8491949}" dt="2023-03-16T12:15:23.654" v="112" actId="20577"/>
          <ac:spMkLst>
            <pc:docMk/>
            <pc:sldMk cId="2536174185" sldId="256"/>
            <ac:spMk id="26" creationId="{834BE626-D0C8-4FF1-9815-8CB0FB731A37}"/>
          </ac:spMkLst>
        </pc:spChg>
        <pc:spChg chg="mod">
          <ac:chgData name="住吉 秀太郎" userId="f57d79c7034a3c66" providerId="LiveId" clId="{743CD99B-4BC1-4438-8861-7A02D8491949}" dt="2023-03-16T12:15:43.910" v="119" actId="1076"/>
          <ac:spMkLst>
            <pc:docMk/>
            <pc:sldMk cId="2536174185" sldId="256"/>
            <ac:spMk id="27" creationId="{CB837268-13ED-4BA4-B565-E5AA47C93E90}"/>
          </ac:spMkLst>
        </pc:spChg>
        <pc:spChg chg="mod">
          <ac:chgData name="住吉 秀太郎" userId="f57d79c7034a3c66" providerId="LiveId" clId="{743CD99B-4BC1-4438-8861-7A02D8491949}" dt="2023-03-16T12:15:43.910" v="119" actId="1076"/>
          <ac:spMkLst>
            <pc:docMk/>
            <pc:sldMk cId="2536174185" sldId="256"/>
            <ac:spMk id="28" creationId="{98FB1D8B-BBB5-45CF-82CE-D7E34F73E59A}"/>
          </ac:spMkLst>
        </pc:spChg>
        <pc:spChg chg="mod">
          <ac:chgData name="住吉 秀太郎" userId="f57d79c7034a3c66" providerId="LiveId" clId="{743CD99B-4BC1-4438-8861-7A02D8491949}" dt="2023-03-16T12:18:28.387" v="160" actId="20577"/>
          <ac:spMkLst>
            <pc:docMk/>
            <pc:sldMk cId="2536174185" sldId="256"/>
            <ac:spMk id="29" creationId="{845A64FE-B849-4B62-A492-94E374C27CCC}"/>
          </ac:spMkLst>
        </pc:spChg>
        <pc:spChg chg="del topLvl">
          <ac:chgData name="住吉 秀太郎" userId="f57d79c7034a3c66" providerId="LiveId" clId="{743CD99B-4BC1-4438-8861-7A02D8491949}" dt="2023-03-16T12:17:39.745" v="140" actId="478"/>
          <ac:spMkLst>
            <pc:docMk/>
            <pc:sldMk cId="2536174185" sldId="256"/>
            <ac:spMk id="31" creationId="{B60DF8B2-327C-4248-A523-00CAB393CB99}"/>
          </ac:spMkLst>
        </pc:spChg>
        <pc:spChg chg="del topLvl">
          <ac:chgData name="住吉 秀太郎" userId="f57d79c7034a3c66" providerId="LiveId" clId="{743CD99B-4BC1-4438-8861-7A02D8491949}" dt="2023-03-16T12:15:55.985" v="120" actId="478"/>
          <ac:spMkLst>
            <pc:docMk/>
            <pc:sldMk cId="2536174185" sldId="256"/>
            <ac:spMk id="32" creationId="{53CA80B4-7929-490D-9081-7EF234ECA4F0}"/>
          </ac:spMkLst>
        </pc:spChg>
        <pc:spChg chg="del">
          <ac:chgData name="住吉 秀太郎" userId="f57d79c7034a3c66" providerId="LiveId" clId="{743CD99B-4BC1-4438-8861-7A02D8491949}" dt="2023-03-16T12:14:43.565" v="101" actId="478"/>
          <ac:spMkLst>
            <pc:docMk/>
            <pc:sldMk cId="2536174185" sldId="256"/>
            <ac:spMk id="39" creationId="{264F7C54-1154-4A10-A003-62258A7A0310}"/>
          </ac:spMkLst>
        </pc:spChg>
        <pc:spChg chg="mod">
          <ac:chgData name="住吉 秀太郎" userId="f57d79c7034a3c66" providerId="LiveId" clId="{743CD99B-4BC1-4438-8861-7A02D8491949}" dt="2023-03-16T12:05:29.406" v="12"/>
          <ac:spMkLst>
            <pc:docMk/>
            <pc:sldMk cId="2536174185" sldId="256"/>
            <ac:spMk id="40" creationId="{93CFEB9B-711D-96D9-9518-BECE17ABC87C}"/>
          </ac:spMkLst>
        </pc:spChg>
        <pc:spChg chg="mod">
          <ac:chgData name="住吉 秀太郎" userId="f57d79c7034a3c66" providerId="LiveId" clId="{743CD99B-4BC1-4438-8861-7A02D8491949}" dt="2023-03-16T12:05:29.406" v="12"/>
          <ac:spMkLst>
            <pc:docMk/>
            <pc:sldMk cId="2536174185" sldId="256"/>
            <ac:spMk id="41" creationId="{5B17F864-E27E-A966-E0D1-2C66160699C5}"/>
          </ac:spMkLst>
        </pc:spChg>
        <pc:spChg chg="del">
          <ac:chgData name="住吉 秀太郎" userId="f57d79c7034a3c66" providerId="LiveId" clId="{743CD99B-4BC1-4438-8861-7A02D8491949}" dt="2023-03-16T12:14:02.708" v="94" actId="478"/>
          <ac:spMkLst>
            <pc:docMk/>
            <pc:sldMk cId="2536174185" sldId="256"/>
            <ac:spMk id="43" creationId="{C4477E22-4C32-4A7C-942A-33775DB9FAC7}"/>
          </ac:spMkLst>
        </pc:spChg>
        <pc:spChg chg="del">
          <ac:chgData name="住吉 秀太郎" userId="f57d79c7034a3c66" providerId="LiveId" clId="{743CD99B-4BC1-4438-8861-7A02D8491949}" dt="2023-03-16T12:14:05.508" v="95" actId="478"/>
          <ac:spMkLst>
            <pc:docMk/>
            <pc:sldMk cId="2536174185" sldId="256"/>
            <ac:spMk id="44" creationId="{5FBBED01-A4DA-4B0F-AEF4-E004E362FE64}"/>
          </ac:spMkLst>
        </pc:spChg>
        <pc:spChg chg="mod">
          <ac:chgData name="住吉 秀太郎" userId="f57d79c7034a3c66" providerId="LiveId" clId="{743CD99B-4BC1-4438-8861-7A02D8491949}" dt="2023-03-16T12:06:13.469" v="35" actId="404"/>
          <ac:spMkLst>
            <pc:docMk/>
            <pc:sldMk cId="2536174185" sldId="256"/>
            <ac:spMk id="46" creationId="{BC9B4DDA-CAD7-3AA9-7362-590BAC1E7F57}"/>
          </ac:spMkLst>
        </pc:spChg>
        <pc:spChg chg="mod">
          <ac:chgData name="住吉 秀太郎" userId="f57d79c7034a3c66" providerId="LiveId" clId="{743CD99B-4BC1-4438-8861-7A02D8491949}" dt="2023-03-16T12:06:13.469" v="35" actId="404"/>
          <ac:spMkLst>
            <pc:docMk/>
            <pc:sldMk cId="2536174185" sldId="256"/>
            <ac:spMk id="48" creationId="{7E8E9E81-AFEF-92D5-7F4C-B6D4AD3F608F}"/>
          </ac:spMkLst>
        </pc:spChg>
        <pc:spChg chg="mod">
          <ac:chgData name="住吉 秀太郎" userId="f57d79c7034a3c66" providerId="LiveId" clId="{743CD99B-4BC1-4438-8861-7A02D8491949}" dt="2023-03-16T12:06:13.469" v="35" actId="404"/>
          <ac:spMkLst>
            <pc:docMk/>
            <pc:sldMk cId="2536174185" sldId="256"/>
            <ac:spMk id="49" creationId="{A49E670F-D1C0-9B47-A3DA-8810FFE1D648}"/>
          </ac:spMkLst>
        </pc:spChg>
        <pc:spChg chg="mod">
          <ac:chgData name="住吉 秀太郎" userId="f57d79c7034a3c66" providerId="LiveId" clId="{743CD99B-4BC1-4438-8861-7A02D8491949}" dt="2023-03-16T12:06:13.469" v="35" actId="404"/>
          <ac:spMkLst>
            <pc:docMk/>
            <pc:sldMk cId="2536174185" sldId="256"/>
            <ac:spMk id="50" creationId="{BE77FB0D-BAF2-BA94-9EAA-B3A368FDB7DC}"/>
          </ac:spMkLst>
        </pc:spChg>
        <pc:spChg chg="add mod">
          <ac:chgData name="住吉 秀太郎" userId="f57d79c7034a3c66" providerId="LiveId" clId="{743CD99B-4BC1-4438-8861-7A02D8491949}" dt="2023-03-16T12:16:02.907" v="122" actId="1076"/>
          <ac:spMkLst>
            <pc:docMk/>
            <pc:sldMk cId="2536174185" sldId="256"/>
            <ac:spMk id="53" creationId="{FC083BB5-3BC3-27C9-CD7D-9861ECFD271D}"/>
          </ac:spMkLst>
        </pc:spChg>
        <pc:grpChg chg="mod">
          <ac:chgData name="住吉 秀太郎" userId="f57d79c7034a3c66" providerId="LiveId" clId="{743CD99B-4BC1-4438-8861-7A02D8491949}" dt="2023-03-16T12:14:58.867" v="103" actId="1076"/>
          <ac:grpSpMkLst>
            <pc:docMk/>
            <pc:sldMk cId="2536174185" sldId="256"/>
            <ac:grpSpMk id="2" creationId="{B7152FE5-B738-4C17-8C06-050F79EF6DC4}"/>
          </ac:grpSpMkLst>
        </pc:grpChg>
        <pc:grpChg chg="del">
          <ac:chgData name="住吉 秀太郎" userId="f57d79c7034a3c66" providerId="LiveId" clId="{743CD99B-4BC1-4438-8861-7A02D8491949}" dt="2023-03-16T12:16:17.546" v="127" actId="478"/>
          <ac:grpSpMkLst>
            <pc:docMk/>
            <pc:sldMk cId="2536174185" sldId="256"/>
            <ac:grpSpMk id="8" creationId="{2833BA2A-6954-40B4-857A-424E6AE35F51}"/>
          </ac:grpSpMkLst>
        </pc:grpChg>
        <pc:grpChg chg="add del mod">
          <ac:chgData name="住吉 秀太郎" userId="f57d79c7034a3c66" providerId="LiveId" clId="{743CD99B-4BC1-4438-8861-7A02D8491949}" dt="2023-03-16T12:05:31.233" v="13"/>
          <ac:grpSpMkLst>
            <pc:docMk/>
            <pc:sldMk cId="2536174185" sldId="256"/>
            <ac:grpSpMk id="10" creationId="{AC3E2702-F056-1EC1-BC1B-6F8B5CB4840B}"/>
          </ac:grpSpMkLst>
        </pc:grpChg>
        <pc:grpChg chg="mod">
          <ac:chgData name="住吉 秀太郎" userId="f57d79c7034a3c66" providerId="LiveId" clId="{743CD99B-4BC1-4438-8861-7A02D8491949}" dt="2023-03-16T12:05:29.406" v="12"/>
          <ac:grpSpMkLst>
            <pc:docMk/>
            <pc:sldMk cId="2536174185" sldId="256"/>
            <ac:grpSpMk id="11" creationId="{591631D1-DFC0-99C3-5889-3689359215B0}"/>
          </ac:grpSpMkLst>
        </pc:grpChg>
        <pc:grpChg chg="add del">
          <ac:chgData name="住吉 秀太郎" userId="f57d79c7034a3c66" providerId="LiveId" clId="{743CD99B-4BC1-4438-8861-7A02D8491949}" dt="2023-03-16T12:16:07.825" v="124" actId="478"/>
          <ac:grpSpMkLst>
            <pc:docMk/>
            <pc:sldMk cId="2536174185" sldId="256"/>
            <ac:grpSpMk id="22" creationId="{3BCDBFEC-CAB1-41FF-A8E2-0E5633C47003}"/>
          </ac:grpSpMkLst>
        </pc:grpChg>
        <pc:grpChg chg="del">
          <ac:chgData name="住吉 秀太郎" userId="f57d79c7034a3c66" providerId="LiveId" clId="{743CD99B-4BC1-4438-8861-7A02D8491949}" dt="2023-03-16T12:15:55.985" v="120" actId="478"/>
          <ac:grpSpMkLst>
            <pc:docMk/>
            <pc:sldMk cId="2536174185" sldId="256"/>
            <ac:grpSpMk id="30" creationId="{2B5A8E44-08F5-405E-9CFF-9412529DE755}"/>
          </ac:grpSpMkLst>
        </pc:grpChg>
        <pc:grpChg chg="add del mod">
          <ac:chgData name="住吉 秀太郎" userId="f57d79c7034a3c66" providerId="LiveId" clId="{743CD99B-4BC1-4438-8861-7A02D8491949}" dt="2023-03-16T12:06:35.299" v="41"/>
          <ac:grpSpMkLst>
            <pc:docMk/>
            <pc:sldMk cId="2536174185" sldId="256"/>
            <ac:grpSpMk id="42" creationId="{1812F3E3-402B-9CA2-42AE-CBC2192DF67F}"/>
          </ac:grpSpMkLst>
        </pc:grpChg>
        <pc:grpChg chg="mod">
          <ac:chgData name="住吉 秀太郎" userId="f57d79c7034a3c66" providerId="LiveId" clId="{743CD99B-4BC1-4438-8861-7A02D8491949}" dt="2023-03-16T12:05:35.088" v="14"/>
          <ac:grpSpMkLst>
            <pc:docMk/>
            <pc:sldMk cId="2536174185" sldId="256"/>
            <ac:grpSpMk id="45" creationId="{774D77FD-840B-4C50-F7FD-2753FA597627}"/>
          </ac:grpSpMkLst>
        </pc:grpChg>
        <pc:picChg chg="add mod ord modCrop">
          <ac:chgData name="住吉 秀太郎" userId="f57d79c7034a3c66" providerId="LiveId" clId="{743CD99B-4BC1-4438-8861-7A02D8491949}" dt="2023-03-16T12:17:23.265" v="138" actId="167"/>
          <ac:picMkLst>
            <pc:docMk/>
            <pc:sldMk cId="2536174185" sldId="256"/>
            <ac:picMk id="9" creationId="{16885575-076F-5032-2706-240EF35D15C9}"/>
          </ac:picMkLst>
        </pc:picChg>
        <pc:picChg chg="mod">
          <ac:chgData name="住吉 秀太郎" userId="f57d79c7034a3c66" providerId="LiveId" clId="{743CD99B-4BC1-4438-8861-7A02D8491949}" dt="2023-03-16T12:05:29.406" v="12"/>
          <ac:picMkLst>
            <pc:docMk/>
            <pc:sldMk cId="2536174185" sldId="256"/>
            <ac:picMk id="13" creationId="{E7575828-E52F-DD13-67DB-735F08BE2FCB}"/>
          </ac:picMkLst>
        </pc:picChg>
        <pc:picChg chg="del">
          <ac:chgData name="住吉 秀太郎" userId="f57d79c7034a3c66" providerId="LiveId" clId="{743CD99B-4BC1-4438-8861-7A02D8491949}" dt="2023-03-16T12:16:10.947" v="125" actId="478"/>
          <ac:picMkLst>
            <pc:docMk/>
            <pc:sldMk cId="2536174185" sldId="256"/>
            <ac:picMk id="21" creationId="{EF7FDB99-D6FB-4962-959B-E041DFD750EB}"/>
          </ac:picMkLst>
        </pc:picChg>
        <pc:picChg chg="add del">
          <ac:chgData name="住吉 秀太郎" userId="f57d79c7034a3c66" providerId="LiveId" clId="{743CD99B-4BC1-4438-8861-7A02D8491949}" dt="2023-03-16T11:50:13.508" v="6" actId="478"/>
          <ac:picMkLst>
            <pc:docMk/>
            <pc:sldMk cId="2536174185" sldId="256"/>
            <ac:picMk id="24" creationId="{311C0649-EB00-4C5A-8A51-BC33FA402EDF}"/>
          </ac:picMkLst>
        </pc:picChg>
        <pc:picChg chg="add del mod">
          <ac:chgData name="住吉 秀太郎" userId="f57d79c7034a3c66" providerId="LiveId" clId="{743CD99B-4BC1-4438-8861-7A02D8491949}" dt="2023-03-16T12:06:13.650" v="36" actId="478"/>
          <ac:picMkLst>
            <pc:docMk/>
            <pc:sldMk cId="2536174185" sldId="256"/>
            <ac:picMk id="47" creationId="{A81596EA-1C54-EA50-424B-8A46DAE73BA2}"/>
          </ac:picMkLst>
        </pc:picChg>
        <pc:picChg chg="add mod ord modCrop">
          <ac:chgData name="住吉 秀太郎" userId="f57d79c7034a3c66" providerId="LiveId" clId="{743CD99B-4BC1-4438-8861-7A02D8491949}" dt="2023-03-16T12:14:52.621" v="102" actId="1076"/>
          <ac:picMkLst>
            <pc:docMk/>
            <pc:sldMk cId="2536174185" sldId="256"/>
            <ac:picMk id="52" creationId="{ACFFEB24-7693-95E3-FA6E-97E4848CBBD6}"/>
          </ac:picMkLst>
        </pc:picChg>
      </pc:sldChg>
      <pc:sldChg chg="addSp delSp modSp add mod">
        <pc:chgData name="住吉 秀太郎" userId="f57d79c7034a3c66" providerId="LiveId" clId="{743CD99B-4BC1-4438-8861-7A02D8491949}" dt="2023-03-18T13:20:26.227" v="784" actId="1036"/>
        <pc:sldMkLst>
          <pc:docMk/>
          <pc:sldMk cId="1006072431" sldId="257"/>
        </pc:sldMkLst>
        <pc:spChg chg="del">
          <ac:chgData name="住吉 秀太郎" userId="f57d79c7034a3c66" providerId="LiveId" clId="{743CD99B-4BC1-4438-8861-7A02D8491949}" dt="2023-03-18T08:14:50.759" v="240" actId="478"/>
          <ac:spMkLst>
            <pc:docMk/>
            <pc:sldMk cId="1006072431" sldId="257"/>
            <ac:spMk id="3" creationId="{BAC6F3F3-AF1C-406D-9911-E783711A4A72}"/>
          </ac:spMkLst>
        </pc:spChg>
        <pc:spChg chg="del">
          <ac:chgData name="住吉 秀太郎" userId="f57d79c7034a3c66" providerId="LiveId" clId="{743CD99B-4BC1-4438-8861-7A02D8491949}" dt="2023-03-18T08:32:07.337" v="329" actId="478"/>
          <ac:spMkLst>
            <pc:docMk/>
            <pc:sldMk cId="1006072431" sldId="257"/>
            <ac:spMk id="5" creationId="{C967F096-0174-4D36-A714-941B6EAEAEA7}"/>
          </ac:spMkLst>
        </pc:spChg>
        <pc:spChg chg="add mod">
          <ac:chgData name="住吉 秀太郎" userId="f57d79c7034a3c66" providerId="LiveId" clId="{743CD99B-4BC1-4438-8861-7A02D8491949}" dt="2023-03-18T13:20:26.227" v="784" actId="1036"/>
          <ac:spMkLst>
            <pc:docMk/>
            <pc:sldMk cId="1006072431" sldId="257"/>
            <ac:spMk id="7" creationId="{92FC807B-950C-5472-705B-C09291DC4B2A}"/>
          </ac:spMkLst>
        </pc:spChg>
        <pc:spChg chg="add mod">
          <ac:chgData name="住吉 秀太郎" userId="f57d79c7034a3c66" providerId="LiveId" clId="{743CD99B-4BC1-4438-8861-7A02D8491949}" dt="2023-03-18T13:20:26.227" v="784" actId="1036"/>
          <ac:spMkLst>
            <pc:docMk/>
            <pc:sldMk cId="1006072431" sldId="257"/>
            <ac:spMk id="8" creationId="{B88FF316-CF52-3480-1763-2635194FB4C0}"/>
          </ac:spMkLst>
        </pc:spChg>
        <pc:spChg chg="add mod">
          <ac:chgData name="住吉 秀太郎" userId="f57d79c7034a3c66" providerId="LiveId" clId="{743CD99B-4BC1-4438-8861-7A02D8491949}" dt="2023-03-18T13:20:26.227" v="784" actId="1036"/>
          <ac:spMkLst>
            <pc:docMk/>
            <pc:sldMk cId="1006072431" sldId="257"/>
            <ac:spMk id="10" creationId="{656B29DA-820F-4591-2C9D-18B963891B32}"/>
          </ac:spMkLst>
        </pc:spChg>
        <pc:spChg chg="add del mod">
          <ac:chgData name="住吉 秀太郎" userId="f57d79c7034a3c66" providerId="LiveId" clId="{743CD99B-4BC1-4438-8861-7A02D8491949}" dt="2023-03-18T08:42:07.496" v="603" actId="478"/>
          <ac:spMkLst>
            <pc:docMk/>
            <pc:sldMk cId="1006072431" sldId="257"/>
            <ac:spMk id="13" creationId="{868AB0D3-9F25-CE83-CD92-5CFBA813085D}"/>
          </ac:spMkLst>
        </pc:spChg>
        <pc:spChg chg="add del mod">
          <ac:chgData name="住吉 秀太郎" userId="f57d79c7034a3c66" providerId="LiveId" clId="{743CD99B-4BC1-4438-8861-7A02D8491949}" dt="2023-03-18T08:42:11.477" v="605" actId="478"/>
          <ac:spMkLst>
            <pc:docMk/>
            <pc:sldMk cId="1006072431" sldId="257"/>
            <ac:spMk id="14" creationId="{8972A98D-1484-C3D3-E2E5-A9091050FDC1}"/>
          </ac:spMkLst>
        </pc:spChg>
        <pc:spChg chg="mod">
          <ac:chgData name="住吉 秀太郎" userId="f57d79c7034a3c66" providerId="LiveId" clId="{743CD99B-4BC1-4438-8861-7A02D8491949}" dt="2023-03-18T08:30:08.768" v="263"/>
          <ac:spMkLst>
            <pc:docMk/>
            <pc:sldMk cId="1006072431" sldId="257"/>
            <ac:spMk id="17" creationId="{4FD45669-2DC7-48FE-B789-263EDE7352E6}"/>
          </ac:spMkLst>
        </pc:spChg>
        <pc:spChg chg="add del mod">
          <ac:chgData name="住吉 秀太郎" userId="f57d79c7034a3c66" providerId="LiveId" clId="{743CD99B-4BC1-4438-8861-7A02D8491949}" dt="2023-03-18T08:31:40.883" v="325" actId="478"/>
          <ac:spMkLst>
            <pc:docMk/>
            <pc:sldMk cId="1006072431" sldId="257"/>
            <ac:spMk id="21" creationId="{A345C8C1-49B6-A382-9CF5-40204E340358}"/>
          </ac:spMkLst>
        </pc:spChg>
        <pc:spChg chg="add mod">
          <ac:chgData name="住吉 秀太郎" userId="f57d79c7034a3c66" providerId="LiveId" clId="{743CD99B-4BC1-4438-8861-7A02D8491949}" dt="2023-03-18T13:20:26.227" v="784" actId="1036"/>
          <ac:spMkLst>
            <pc:docMk/>
            <pc:sldMk cId="1006072431" sldId="257"/>
            <ac:spMk id="24" creationId="{662FDB66-065E-F780-B68C-9394AF9F9239}"/>
          </ac:spMkLst>
        </pc:spChg>
        <pc:spChg chg="mod">
          <ac:chgData name="住吉 秀太郎" userId="f57d79c7034a3c66" providerId="LiveId" clId="{743CD99B-4BC1-4438-8861-7A02D8491949}" dt="2023-03-18T13:20:26.227" v="784" actId="1036"/>
          <ac:spMkLst>
            <pc:docMk/>
            <pc:sldMk cId="1006072431" sldId="257"/>
            <ac:spMk id="25" creationId="{35DFF634-96C1-4056-8171-AC743426A99F}"/>
          </ac:spMkLst>
        </pc:spChg>
        <pc:spChg chg="mod">
          <ac:chgData name="住吉 秀太郎" userId="f57d79c7034a3c66" providerId="LiveId" clId="{743CD99B-4BC1-4438-8861-7A02D8491949}" dt="2023-03-18T13:20:26.227" v="784" actId="1036"/>
          <ac:spMkLst>
            <pc:docMk/>
            <pc:sldMk cId="1006072431" sldId="257"/>
            <ac:spMk id="26" creationId="{834BE626-D0C8-4FF1-9815-8CB0FB731A37}"/>
          </ac:spMkLst>
        </pc:spChg>
        <pc:spChg chg="del">
          <ac:chgData name="住吉 秀太郎" userId="f57d79c7034a3c66" providerId="LiveId" clId="{743CD99B-4BC1-4438-8861-7A02D8491949}" dt="2023-03-18T08:14:10.669" v="215" actId="478"/>
          <ac:spMkLst>
            <pc:docMk/>
            <pc:sldMk cId="1006072431" sldId="257"/>
            <ac:spMk id="27" creationId="{CB837268-13ED-4BA4-B565-E5AA47C93E90}"/>
          </ac:spMkLst>
        </pc:spChg>
        <pc:spChg chg="del mod">
          <ac:chgData name="住吉 秀太郎" userId="f57d79c7034a3c66" providerId="LiveId" clId="{743CD99B-4BC1-4438-8861-7A02D8491949}" dt="2023-03-18T08:14:13.691" v="217" actId="478"/>
          <ac:spMkLst>
            <pc:docMk/>
            <pc:sldMk cId="1006072431" sldId="257"/>
            <ac:spMk id="28" creationId="{98FB1D8B-BBB5-45CF-82CE-D7E34F73E59A}"/>
          </ac:spMkLst>
        </pc:spChg>
        <pc:spChg chg="mod">
          <ac:chgData name="住吉 秀太郎" userId="f57d79c7034a3c66" providerId="LiveId" clId="{743CD99B-4BC1-4438-8861-7A02D8491949}" dt="2023-03-18T13:20:26.227" v="784" actId="1036"/>
          <ac:spMkLst>
            <pc:docMk/>
            <pc:sldMk cId="1006072431" sldId="257"/>
            <ac:spMk id="29" creationId="{845A64FE-B849-4B62-A492-94E374C27CCC}"/>
          </ac:spMkLst>
        </pc:spChg>
        <pc:spChg chg="add mod">
          <ac:chgData name="住吉 秀太郎" userId="f57d79c7034a3c66" providerId="LiveId" clId="{743CD99B-4BC1-4438-8861-7A02D8491949}" dt="2023-03-18T13:20:26.227" v="784" actId="1036"/>
          <ac:spMkLst>
            <pc:docMk/>
            <pc:sldMk cId="1006072431" sldId="257"/>
            <ac:spMk id="30" creationId="{B5509892-082D-9318-F728-74A102B04B8F}"/>
          </ac:spMkLst>
        </pc:spChg>
        <pc:spChg chg="del">
          <ac:chgData name="住吉 秀太郎" userId="f57d79c7034a3c66" providerId="LiveId" clId="{743CD99B-4BC1-4438-8861-7A02D8491949}" dt="2023-03-18T08:34:47.392" v="432" actId="478"/>
          <ac:spMkLst>
            <pc:docMk/>
            <pc:sldMk cId="1006072431" sldId="257"/>
            <ac:spMk id="33" creationId="{7871CE0B-C683-4B40-BA9B-882111A27EFA}"/>
          </ac:spMkLst>
        </pc:spChg>
        <pc:spChg chg="mod">
          <ac:chgData name="住吉 秀太郎" userId="f57d79c7034a3c66" providerId="LiveId" clId="{743CD99B-4BC1-4438-8861-7A02D8491949}" dt="2023-03-18T13:20:26.227" v="784" actId="1036"/>
          <ac:spMkLst>
            <pc:docMk/>
            <pc:sldMk cId="1006072431" sldId="257"/>
            <ac:spMk id="34" creationId="{79321D6F-14DC-407B-9D1F-8B408A58E9D1}"/>
          </ac:spMkLst>
        </pc:spChg>
        <pc:spChg chg="mod">
          <ac:chgData name="住吉 秀太郎" userId="f57d79c7034a3c66" providerId="LiveId" clId="{743CD99B-4BC1-4438-8861-7A02D8491949}" dt="2023-03-18T13:20:26.227" v="784" actId="1036"/>
          <ac:spMkLst>
            <pc:docMk/>
            <pc:sldMk cId="1006072431" sldId="257"/>
            <ac:spMk id="35" creationId="{D262662E-F6DA-46C4-B78A-7F59559B099E}"/>
          </ac:spMkLst>
        </pc:spChg>
        <pc:spChg chg="mod">
          <ac:chgData name="住吉 秀太郎" userId="f57d79c7034a3c66" providerId="LiveId" clId="{743CD99B-4BC1-4438-8861-7A02D8491949}" dt="2023-03-18T13:20:26.227" v="784" actId="1036"/>
          <ac:spMkLst>
            <pc:docMk/>
            <pc:sldMk cId="1006072431" sldId="257"/>
            <ac:spMk id="36" creationId="{280D40BE-DFF7-40D3-A52A-E4E90C057E47}"/>
          </ac:spMkLst>
        </pc:spChg>
        <pc:spChg chg="add mod">
          <ac:chgData name="住吉 秀太郎" userId="f57d79c7034a3c66" providerId="LiveId" clId="{743CD99B-4BC1-4438-8861-7A02D8491949}" dt="2023-03-18T13:20:26.227" v="784" actId="1036"/>
          <ac:spMkLst>
            <pc:docMk/>
            <pc:sldMk cId="1006072431" sldId="257"/>
            <ac:spMk id="37" creationId="{533C8474-CC33-F98B-6BB1-B22EA7A9B6DC}"/>
          </ac:spMkLst>
        </pc:spChg>
        <pc:spChg chg="del">
          <ac:chgData name="住吉 秀太郎" userId="f57d79c7034a3c66" providerId="LiveId" clId="{743CD99B-4BC1-4438-8861-7A02D8491949}" dt="2023-03-18T08:32:04.688" v="328" actId="478"/>
          <ac:spMkLst>
            <pc:docMk/>
            <pc:sldMk cId="1006072431" sldId="257"/>
            <ac:spMk id="38" creationId="{26535FA5-25CA-40A1-AC69-0738CBB19DB0}"/>
          </ac:spMkLst>
        </pc:spChg>
        <pc:spChg chg="add mod">
          <ac:chgData name="住吉 秀太郎" userId="f57d79c7034a3c66" providerId="LiveId" clId="{743CD99B-4BC1-4438-8861-7A02D8491949}" dt="2023-03-18T13:20:26.227" v="784" actId="1036"/>
          <ac:spMkLst>
            <pc:docMk/>
            <pc:sldMk cId="1006072431" sldId="257"/>
            <ac:spMk id="39" creationId="{F325755C-8B94-AAD7-A684-17D8EF9574D4}"/>
          </ac:spMkLst>
        </pc:spChg>
        <pc:spChg chg="add mod">
          <ac:chgData name="住吉 秀太郎" userId="f57d79c7034a3c66" providerId="LiveId" clId="{743CD99B-4BC1-4438-8861-7A02D8491949}" dt="2023-03-18T13:20:26.227" v="784" actId="1036"/>
          <ac:spMkLst>
            <pc:docMk/>
            <pc:sldMk cId="1006072431" sldId="257"/>
            <ac:spMk id="40" creationId="{6E7B23ED-C619-F45E-99FF-FB91A461D576}"/>
          </ac:spMkLst>
        </pc:spChg>
        <pc:spChg chg="add mod">
          <ac:chgData name="住吉 秀太郎" userId="f57d79c7034a3c66" providerId="LiveId" clId="{743CD99B-4BC1-4438-8861-7A02D8491949}" dt="2023-03-18T13:20:26.227" v="784" actId="1036"/>
          <ac:spMkLst>
            <pc:docMk/>
            <pc:sldMk cId="1006072431" sldId="257"/>
            <ac:spMk id="41" creationId="{D774674C-0D1F-FF24-FCA6-7E8E9627C9E1}"/>
          </ac:spMkLst>
        </pc:spChg>
        <pc:spChg chg="mod">
          <ac:chgData name="住吉 秀太郎" userId="f57d79c7034a3c66" providerId="LiveId" clId="{743CD99B-4BC1-4438-8861-7A02D8491949}" dt="2023-03-18T08:32:14.328" v="330"/>
          <ac:spMkLst>
            <pc:docMk/>
            <pc:sldMk cId="1006072431" sldId="257"/>
            <ac:spMk id="43" creationId="{9C06038D-58C9-862D-9C08-6B87A0390B94}"/>
          </ac:spMkLst>
        </pc:spChg>
        <pc:spChg chg="mod">
          <ac:chgData name="住吉 秀太郎" userId="f57d79c7034a3c66" providerId="LiveId" clId="{743CD99B-4BC1-4438-8861-7A02D8491949}" dt="2023-03-18T08:32:14.328" v="330"/>
          <ac:spMkLst>
            <pc:docMk/>
            <pc:sldMk cId="1006072431" sldId="257"/>
            <ac:spMk id="44" creationId="{E08AABA4-2088-8F5E-2AE1-558AE0CBA7B2}"/>
          </ac:spMkLst>
        </pc:spChg>
        <pc:spChg chg="add del mod">
          <ac:chgData name="住吉 秀太郎" userId="f57d79c7034a3c66" providerId="LiveId" clId="{743CD99B-4BC1-4438-8861-7A02D8491949}" dt="2023-03-18T08:37:17.857" v="514" actId="478"/>
          <ac:spMkLst>
            <pc:docMk/>
            <pc:sldMk cId="1006072431" sldId="257"/>
            <ac:spMk id="45" creationId="{F4FC7BE2-1C13-0FE3-57D0-5068E4070CDD}"/>
          </ac:spMkLst>
        </pc:spChg>
        <pc:spChg chg="add mod">
          <ac:chgData name="住吉 秀太郎" userId="f57d79c7034a3c66" providerId="LiveId" clId="{743CD99B-4BC1-4438-8861-7A02D8491949}" dt="2023-03-18T13:20:26.227" v="784" actId="1036"/>
          <ac:spMkLst>
            <pc:docMk/>
            <pc:sldMk cId="1006072431" sldId="257"/>
            <ac:spMk id="46" creationId="{98877F21-3D68-0D97-C3C9-D9E6B02FA504}"/>
          </ac:spMkLst>
        </pc:spChg>
        <pc:spChg chg="add mod">
          <ac:chgData name="住吉 秀太郎" userId="f57d79c7034a3c66" providerId="LiveId" clId="{743CD99B-4BC1-4438-8861-7A02D8491949}" dt="2023-03-18T13:20:26.227" v="784" actId="1036"/>
          <ac:spMkLst>
            <pc:docMk/>
            <pc:sldMk cId="1006072431" sldId="257"/>
            <ac:spMk id="47" creationId="{E5C49CAE-7298-ADC0-C144-FF6AC9572076}"/>
          </ac:spMkLst>
        </pc:spChg>
        <pc:spChg chg="add mod">
          <ac:chgData name="住吉 秀太郎" userId="f57d79c7034a3c66" providerId="LiveId" clId="{743CD99B-4BC1-4438-8861-7A02D8491949}" dt="2023-03-18T13:20:26.227" v="784" actId="1036"/>
          <ac:spMkLst>
            <pc:docMk/>
            <pc:sldMk cId="1006072431" sldId="257"/>
            <ac:spMk id="48" creationId="{5583FA9C-EC15-2856-CEDF-1213E723FDE9}"/>
          </ac:spMkLst>
        </pc:spChg>
        <pc:spChg chg="add mod">
          <ac:chgData name="住吉 秀太郎" userId="f57d79c7034a3c66" providerId="LiveId" clId="{743CD99B-4BC1-4438-8861-7A02D8491949}" dt="2023-03-18T13:20:26.227" v="784" actId="1036"/>
          <ac:spMkLst>
            <pc:docMk/>
            <pc:sldMk cId="1006072431" sldId="257"/>
            <ac:spMk id="49" creationId="{92EDF058-6A9F-17CE-B926-646EC33BA940}"/>
          </ac:spMkLst>
        </pc:spChg>
        <pc:spChg chg="add mod">
          <ac:chgData name="住吉 秀太郎" userId="f57d79c7034a3c66" providerId="LiveId" clId="{743CD99B-4BC1-4438-8861-7A02D8491949}" dt="2023-03-18T13:20:26.227" v="784" actId="1036"/>
          <ac:spMkLst>
            <pc:docMk/>
            <pc:sldMk cId="1006072431" sldId="257"/>
            <ac:spMk id="50" creationId="{C058A824-4C71-63C0-B6C5-684A1B9C8F2B}"/>
          </ac:spMkLst>
        </pc:spChg>
        <pc:spChg chg="add mod">
          <ac:chgData name="住吉 秀太郎" userId="f57d79c7034a3c66" providerId="LiveId" clId="{743CD99B-4BC1-4438-8861-7A02D8491949}" dt="2023-03-18T13:20:26.227" v="784" actId="1036"/>
          <ac:spMkLst>
            <pc:docMk/>
            <pc:sldMk cId="1006072431" sldId="257"/>
            <ac:spMk id="51" creationId="{F3A43702-0324-00B9-C2B5-6F0261A9B54A}"/>
          </ac:spMkLst>
        </pc:spChg>
        <pc:spChg chg="mod">
          <ac:chgData name="住吉 秀太郎" userId="f57d79c7034a3c66" providerId="LiveId" clId="{743CD99B-4BC1-4438-8861-7A02D8491949}" dt="2023-03-18T13:20:26.227" v="784" actId="1036"/>
          <ac:spMkLst>
            <pc:docMk/>
            <pc:sldMk cId="1006072431" sldId="257"/>
            <ac:spMk id="53" creationId="{FC083BB5-3BC3-27C9-CD7D-9861ECFD271D}"/>
          </ac:spMkLst>
        </pc:spChg>
        <pc:spChg chg="add mod">
          <ac:chgData name="住吉 秀太郎" userId="f57d79c7034a3c66" providerId="LiveId" clId="{743CD99B-4BC1-4438-8861-7A02D8491949}" dt="2023-03-18T13:20:26.227" v="784" actId="1036"/>
          <ac:spMkLst>
            <pc:docMk/>
            <pc:sldMk cId="1006072431" sldId="257"/>
            <ac:spMk id="54" creationId="{E88E9D10-5368-1F99-3D3C-C844EDCFC827}"/>
          </ac:spMkLst>
        </pc:spChg>
        <pc:spChg chg="add mod">
          <ac:chgData name="住吉 秀太郎" userId="f57d79c7034a3c66" providerId="LiveId" clId="{743CD99B-4BC1-4438-8861-7A02D8491949}" dt="2023-03-18T13:20:26.227" v="784" actId="1036"/>
          <ac:spMkLst>
            <pc:docMk/>
            <pc:sldMk cId="1006072431" sldId="257"/>
            <ac:spMk id="55" creationId="{E43D13F3-E491-6001-9A62-3914F2ED7834}"/>
          </ac:spMkLst>
        </pc:spChg>
        <pc:spChg chg="add mod">
          <ac:chgData name="住吉 秀太郎" userId="f57d79c7034a3c66" providerId="LiveId" clId="{743CD99B-4BC1-4438-8861-7A02D8491949}" dt="2023-03-18T13:20:26.227" v="784" actId="1036"/>
          <ac:spMkLst>
            <pc:docMk/>
            <pc:sldMk cId="1006072431" sldId="257"/>
            <ac:spMk id="56" creationId="{36E37D0B-E474-02AE-FC07-804238EB1424}"/>
          </ac:spMkLst>
        </pc:spChg>
        <pc:spChg chg="add mod">
          <ac:chgData name="住吉 秀太郎" userId="f57d79c7034a3c66" providerId="LiveId" clId="{743CD99B-4BC1-4438-8861-7A02D8491949}" dt="2023-03-18T13:20:26.227" v="784" actId="1036"/>
          <ac:spMkLst>
            <pc:docMk/>
            <pc:sldMk cId="1006072431" sldId="257"/>
            <ac:spMk id="57" creationId="{ADBD615E-A3C5-3B79-583F-B6DAE645494D}"/>
          </ac:spMkLst>
        </pc:spChg>
        <pc:spChg chg="add mod">
          <ac:chgData name="住吉 秀太郎" userId="f57d79c7034a3c66" providerId="LiveId" clId="{743CD99B-4BC1-4438-8861-7A02D8491949}" dt="2023-03-18T13:20:26.227" v="784" actId="1036"/>
          <ac:spMkLst>
            <pc:docMk/>
            <pc:sldMk cId="1006072431" sldId="257"/>
            <ac:spMk id="60" creationId="{6FF8FA60-18C7-874E-8F56-2C3A56231AA2}"/>
          </ac:spMkLst>
        </pc:spChg>
        <pc:spChg chg="add mod">
          <ac:chgData name="住吉 秀太郎" userId="f57d79c7034a3c66" providerId="LiveId" clId="{743CD99B-4BC1-4438-8861-7A02D8491949}" dt="2023-03-18T13:20:26.227" v="784" actId="1036"/>
          <ac:spMkLst>
            <pc:docMk/>
            <pc:sldMk cId="1006072431" sldId="257"/>
            <ac:spMk id="61" creationId="{5FF7EB0C-4869-D3B6-F095-F3D9698E89BE}"/>
          </ac:spMkLst>
        </pc:spChg>
        <pc:spChg chg="add mod">
          <ac:chgData name="住吉 秀太郎" userId="f57d79c7034a3c66" providerId="LiveId" clId="{743CD99B-4BC1-4438-8861-7A02D8491949}" dt="2023-03-18T13:20:26.227" v="784" actId="1036"/>
          <ac:spMkLst>
            <pc:docMk/>
            <pc:sldMk cId="1006072431" sldId="257"/>
            <ac:spMk id="64" creationId="{5BD487ED-18CF-EF4B-C5EC-9AF398B5B748}"/>
          </ac:spMkLst>
        </pc:spChg>
        <pc:spChg chg="add mod">
          <ac:chgData name="住吉 秀太郎" userId="f57d79c7034a3c66" providerId="LiveId" clId="{743CD99B-4BC1-4438-8861-7A02D8491949}" dt="2023-03-18T13:20:26.227" v="784" actId="1036"/>
          <ac:spMkLst>
            <pc:docMk/>
            <pc:sldMk cId="1006072431" sldId="257"/>
            <ac:spMk id="65" creationId="{418B0A1F-D37A-1E37-0C84-DE3AD042F97D}"/>
          </ac:spMkLst>
        </pc:spChg>
        <pc:grpChg chg="mod">
          <ac:chgData name="住吉 秀太郎" userId="f57d79c7034a3c66" providerId="LiveId" clId="{743CD99B-4BC1-4438-8861-7A02D8491949}" dt="2023-03-18T13:20:26.227" v="784" actId="1036"/>
          <ac:grpSpMkLst>
            <pc:docMk/>
            <pc:sldMk cId="1006072431" sldId="257"/>
            <ac:grpSpMk id="2" creationId="{B7152FE5-B738-4C17-8C06-050F79EF6DC4}"/>
          </ac:grpSpMkLst>
        </pc:grpChg>
        <pc:grpChg chg="del">
          <ac:chgData name="住吉 秀太郎" userId="f57d79c7034a3c66" providerId="LiveId" clId="{743CD99B-4BC1-4438-8861-7A02D8491949}" dt="2023-03-18T08:30:13.862" v="264" actId="478"/>
          <ac:grpSpMkLst>
            <pc:docMk/>
            <pc:sldMk cId="1006072431" sldId="257"/>
            <ac:grpSpMk id="22" creationId="{3BCDBFEC-CAB1-41FF-A8E2-0E5633C47003}"/>
          </ac:grpSpMkLst>
        </pc:grpChg>
        <pc:grpChg chg="add mod">
          <ac:chgData name="住吉 秀太郎" userId="f57d79c7034a3c66" providerId="LiveId" clId="{743CD99B-4BC1-4438-8861-7A02D8491949}" dt="2023-03-18T13:20:26.227" v="784" actId="1036"/>
          <ac:grpSpMkLst>
            <pc:docMk/>
            <pc:sldMk cId="1006072431" sldId="257"/>
            <ac:grpSpMk id="42" creationId="{2B18BE4E-694F-854B-EAF1-145AD7D58029}"/>
          </ac:grpSpMkLst>
        </pc:grpChg>
        <pc:picChg chg="add mod ord modCrop">
          <ac:chgData name="住吉 秀太郎" userId="f57d79c7034a3c66" providerId="LiveId" clId="{743CD99B-4BC1-4438-8861-7A02D8491949}" dt="2023-03-18T13:20:26.227" v="784" actId="1036"/>
          <ac:picMkLst>
            <pc:docMk/>
            <pc:sldMk cId="1006072431" sldId="257"/>
            <ac:picMk id="6" creationId="{ABF98C49-1EB5-D71C-4588-90DB513FDCF1}"/>
          </ac:picMkLst>
        </pc:picChg>
        <pc:picChg chg="del">
          <ac:chgData name="住吉 秀太郎" userId="f57d79c7034a3c66" providerId="LiveId" clId="{743CD99B-4BC1-4438-8861-7A02D8491949}" dt="2023-03-18T08:26:02.152" v="243" actId="478"/>
          <ac:picMkLst>
            <pc:docMk/>
            <pc:sldMk cId="1006072431" sldId="257"/>
            <ac:picMk id="9" creationId="{16885575-076F-5032-2706-240EF35D15C9}"/>
          </ac:picMkLst>
        </pc:picChg>
        <pc:picChg chg="add del mod ord modCrop">
          <ac:chgData name="住吉 秀太郎" userId="f57d79c7034a3c66" providerId="LiveId" clId="{743CD99B-4BC1-4438-8861-7A02D8491949}" dt="2023-03-18T08:38:31.557" v="563" actId="478"/>
          <ac:picMkLst>
            <pc:docMk/>
            <pc:sldMk cId="1006072431" sldId="257"/>
            <ac:picMk id="12" creationId="{3E054484-47F2-9434-A3D8-FBC314A3CF21}"/>
          </ac:picMkLst>
        </pc:picChg>
        <pc:picChg chg="add mod">
          <ac:chgData name="住吉 秀太郎" userId="f57d79c7034a3c66" providerId="LiveId" clId="{743CD99B-4BC1-4438-8861-7A02D8491949}" dt="2023-03-18T13:20:26.227" v="784" actId="1036"/>
          <ac:picMkLst>
            <pc:docMk/>
            <pc:sldMk cId="1006072431" sldId="257"/>
            <ac:picMk id="31" creationId="{603AE1C6-2696-F15E-6FCF-6739FDA3178F}"/>
          </ac:picMkLst>
        </pc:picChg>
        <pc:picChg chg="add del mod">
          <ac:chgData name="住吉 秀太郎" userId="f57d79c7034a3c66" providerId="LiveId" clId="{743CD99B-4BC1-4438-8861-7A02D8491949}" dt="2023-03-18T08:34:25.289" v="412" actId="478"/>
          <ac:picMkLst>
            <pc:docMk/>
            <pc:sldMk cId="1006072431" sldId="257"/>
            <ac:picMk id="32" creationId="{A6A2B6AD-3765-CA79-1FC4-D520B2F2C762}"/>
          </ac:picMkLst>
        </pc:picChg>
        <pc:picChg chg="del">
          <ac:chgData name="住吉 秀太郎" userId="f57d79c7034a3c66" providerId="LiveId" clId="{743CD99B-4BC1-4438-8861-7A02D8491949}" dt="2023-03-18T08:12:35.400" v="171" actId="478"/>
          <ac:picMkLst>
            <pc:docMk/>
            <pc:sldMk cId="1006072431" sldId="257"/>
            <ac:picMk id="52" creationId="{ACFFEB24-7693-95E3-FA6E-97E4848CBBD6}"/>
          </ac:picMkLst>
        </pc:picChg>
        <pc:picChg chg="add mod ord modCrop">
          <ac:chgData name="住吉 秀太郎" userId="f57d79c7034a3c66" providerId="LiveId" clId="{743CD99B-4BC1-4438-8861-7A02D8491949}" dt="2023-03-18T13:20:26.227" v="784" actId="1036"/>
          <ac:picMkLst>
            <pc:docMk/>
            <pc:sldMk cId="1006072431" sldId="257"/>
            <ac:picMk id="59" creationId="{E7291530-55F3-2F84-3978-6562FB51F490}"/>
          </ac:picMkLst>
        </pc:picChg>
        <pc:picChg chg="add mod ord modCrop">
          <ac:chgData name="住吉 秀太郎" userId="f57d79c7034a3c66" providerId="LiveId" clId="{743CD99B-4BC1-4438-8861-7A02D8491949}" dt="2023-03-18T13:20:26.227" v="784" actId="1036"/>
          <ac:picMkLst>
            <pc:docMk/>
            <pc:sldMk cId="1006072431" sldId="257"/>
            <ac:picMk id="63" creationId="{1E7B869B-F2E5-50B7-384B-3F898D9E968F}"/>
          </ac:picMkLst>
        </pc:picChg>
      </pc:sldChg>
      <pc:sldChg chg="add del">
        <pc:chgData name="住吉 秀太郎" userId="f57d79c7034a3c66" providerId="LiveId" clId="{743CD99B-4BC1-4438-8861-7A02D8491949}" dt="2023-03-16T23:22:48.692" v="162"/>
        <pc:sldMkLst>
          <pc:docMk/>
          <pc:sldMk cId="1790791615" sldId="1401"/>
        </pc:sldMkLst>
      </pc:sldChg>
    </pc:docChg>
  </pc:docChgLst>
  <pc:docChgLst>
    <pc:chgData name="住吉 秀太郎" userId="f57d79c7034a3c66" providerId="LiveId" clId="{1E92C1FC-A02B-42B0-82E8-2154044ECB92}"/>
    <pc:docChg chg="delSld">
      <pc:chgData name="住吉 秀太郎" userId="f57d79c7034a3c66" providerId="LiveId" clId="{1E92C1FC-A02B-42B0-82E8-2154044ECB92}" dt="2023-03-18T13:41:46.462" v="0" actId="47"/>
      <pc:docMkLst>
        <pc:docMk/>
      </pc:docMkLst>
      <pc:sldChg chg="del">
        <pc:chgData name="住吉 秀太郎" userId="f57d79c7034a3c66" providerId="LiveId" clId="{1E92C1FC-A02B-42B0-82E8-2154044ECB92}" dt="2023-03-18T13:41:46.462" v="0" actId="47"/>
        <pc:sldMkLst>
          <pc:docMk/>
          <pc:sldMk cId="2536174185" sldId="256"/>
        </pc:sldMkLst>
      </pc:sldChg>
    </pc:docChg>
  </pc:docChgLst>
  <pc:docChgLst>
    <pc:chgData name="住吉 秀太郎" userId="f57d79c7034a3c66" providerId="LiveId" clId="{817A9A44-2F03-46FE-B6C1-A9E2C2A945E2}"/>
    <pc:docChg chg="custSel modSld">
      <pc:chgData name="住吉 秀太郎" userId="f57d79c7034a3c66" providerId="LiveId" clId="{817A9A44-2F03-46FE-B6C1-A9E2C2A945E2}" dt="2021-10-15T03:42:06.391" v="0" actId="478"/>
      <pc:docMkLst>
        <pc:docMk/>
      </pc:docMkLst>
      <pc:sldChg chg="delSp mod">
        <pc:chgData name="住吉 秀太郎" userId="f57d79c7034a3c66" providerId="LiveId" clId="{817A9A44-2F03-46FE-B6C1-A9E2C2A945E2}" dt="2021-10-15T03:42:06.391" v="0" actId="478"/>
        <pc:sldMkLst>
          <pc:docMk/>
          <pc:sldMk cId="2536174185" sldId="256"/>
        </pc:sldMkLst>
        <pc:spChg chg="del">
          <ac:chgData name="住吉 秀太郎" userId="f57d79c7034a3c66" providerId="LiveId" clId="{817A9A44-2F03-46FE-B6C1-A9E2C2A945E2}" dt="2021-10-15T03:42:06.391" v="0" actId="478"/>
          <ac:spMkLst>
            <pc:docMk/>
            <pc:sldMk cId="2536174185" sldId="256"/>
            <ac:spMk id="6" creationId="{619AFC5E-F95A-425F-A5E7-68064136FD1E}"/>
          </ac:spMkLst>
        </pc:spChg>
      </pc:sldChg>
    </pc:docChg>
  </pc:docChgLst>
  <pc:docChgLst>
    <pc:chgData name="住吉 秀太郎" userId="f57d79c7034a3c66" providerId="LiveId" clId="{7C41AB8A-0AB4-4E3D-875E-6C564E7CB58B}"/>
    <pc:docChg chg="custSel modSld">
      <pc:chgData name="住吉 秀太郎" userId="f57d79c7034a3c66" providerId="LiveId" clId="{7C41AB8A-0AB4-4E3D-875E-6C564E7CB58B}" dt="2022-11-18T09:10:42.871" v="0" actId="478"/>
      <pc:docMkLst>
        <pc:docMk/>
      </pc:docMkLst>
      <pc:sldChg chg="delSp mod">
        <pc:chgData name="住吉 秀太郎" userId="f57d79c7034a3c66" providerId="LiveId" clId="{7C41AB8A-0AB4-4E3D-875E-6C564E7CB58B}" dt="2022-11-18T09:10:42.871" v="0" actId="478"/>
        <pc:sldMkLst>
          <pc:docMk/>
          <pc:sldMk cId="2536174185" sldId="256"/>
        </pc:sldMkLst>
        <pc:spChg chg="del">
          <ac:chgData name="住吉 秀太郎" userId="f57d79c7034a3c66" providerId="LiveId" clId="{7C41AB8A-0AB4-4E3D-875E-6C564E7CB58B}" dt="2022-11-18T09:10:42.871" v="0" actId="478"/>
          <ac:spMkLst>
            <pc:docMk/>
            <pc:sldMk cId="2536174185" sldId="256"/>
            <ac:spMk id="40" creationId="{3A3D43A9-F202-420F-8685-2FABD8FBD900}"/>
          </ac:spMkLst>
        </pc:spChg>
      </pc:sldChg>
    </pc:docChg>
  </pc:docChgLst>
  <pc:docChgLst>
    <pc:chgData name="住吉 秀太郎" userId="f57d79c7034a3c66" providerId="LiveId" clId="{CFDC86D2-9CB3-4959-8B0A-062A6A594B11}"/>
    <pc:docChg chg="modSld">
      <pc:chgData name="住吉 秀太郎" userId="f57d79c7034a3c66" providerId="LiveId" clId="{CFDC86D2-9CB3-4959-8B0A-062A6A594B11}" dt="2021-12-06T07:44:44.273" v="12" actId="1076"/>
      <pc:docMkLst>
        <pc:docMk/>
      </pc:docMkLst>
      <pc:sldChg chg="addSp modSp mod">
        <pc:chgData name="住吉 秀太郎" userId="f57d79c7034a3c66" providerId="LiveId" clId="{CFDC86D2-9CB3-4959-8B0A-062A6A594B11}" dt="2021-12-06T07:44:44.273" v="12" actId="1076"/>
        <pc:sldMkLst>
          <pc:docMk/>
          <pc:sldMk cId="2536174185" sldId="256"/>
        </pc:sldMkLst>
        <pc:spChg chg="add mod">
          <ac:chgData name="住吉 秀太郎" userId="f57d79c7034a3c66" providerId="LiveId" clId="{CFDC86D2-9CB3-4959-8B0A-062A6A594B11}" dt="2021-12-06T07:44:16.880" v="6" actId="1076"/>
          <ac:spMkLst>
            <pc:docMk/>
            <pc:sldMk cId="2536174185" sldId="256"/>
            <ac:spMk id="5" creationId="{C967F096-0174-4D36-A714-941B6EAEAEA7}"/>
          </ac:spMkLst>
        </pc:spChg>
        <pc:spChg chg="add mod">
          <ac:chgData name="住吉 秀太郎" userId="f57d79c7034a3c66" providerId="LiveId" clId="{CFDC86D2-9CB3-4959-8B0A-062A6A594B11}" dt="2021-12-06T07:44:44.273" v="12" actId="1076"/>
          <ac:spMkLst>
            <pc:docMk/>
            <pc:sldMk cId="2536174185" sldId="256"/>
            <ac:spMk id="38" creationId="{26535FA5-25CA-40A1-AC69-0738CBB19DB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9F3930-60C8-401D-9EAA-CF2FBBCB9525}" type="datetimeFigureOut">
              <a:rPr kumimoji="1" lang="ja-JP" altLang="en-US" smtClean="0"/>
              <a:t>2023/3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5CE017-24F7-4B62-ADDD-8EE66E8535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87865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9F3930-60C8-401D-9EAA-CF2FBBCB9525}" type="datetimeFigureOut">
              <a:rPr kumimoji="1" lang="ja-JP" altLang="en-US" smtClean="0"/>
              <a:t>2023/3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5CE017-24F7-4B62-ADDD-8EE66E8535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73730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9F3930-60C8-401D-9EAA-CF2FBBCB9525}" type="datetimeFigureOut">
              <a:rPr kumimoji="1" lang="ja-JP" altLang="en-US" smtClean="0"/>
              <a:t>2023/3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5CE017-24F7-4B62-ADDD-8EE66E8535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3818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9F3930-60C8-401D-9EAA-CF2FBBCB9525}" type="datetimeFigureOut">
              <a:rPr kumimoji="1" lang="ja-JP" altLang="en-US" smtClean="0"/>
              <a:t>2023/3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5CE017-24F7-4B62-ADDD-8EE66E8535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57734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9F3930-60C8-401D-9EAA-CF2FBBCB9525}" type="datetimeFigureOut">
              <a:rPr kumimoji="1" lang="ja-JP" altLang="en-US" smtClean="0"/>
              <a:t>2023/3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5CE017-24F7-4B62-ADDD-8EE66E8535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8518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9F3930-60C8-401D-9EAA-CF2FBBCB9525}" type="datetimeFigureOut">
              <a:rPr kumimoji="1" lang="ja-JP" altLang="en-US" smtClean="0"/>
              <a:t>2023/3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5CE017-24F7-4B62-ADDD-8EE66E8535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05657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9F3930-60C8-401D-9EAA-CF2FBBCB9525}" type="datetimeFigureOut">
              <a:rPr kumimoji="1" lang="ja-JP" altLang="en-US" smtClean="0"/>
              <a:t>2023/3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5CE017-24F7-4B62-ADDD-8EE66E8535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98331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9F3930-60C8-401D-9EAA-CF2FBBCB9525}" type="datetimeFigureOut">
              <a:rPr kumimoji="1" lang="ja-JP" altLang="en-US" smtClean="0"/>
              <a:t>2023/3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5CE017-24F7-4B62-ADDD-8EE66E8535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36112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9F3930-60C8-401D-9EAA-CF2FBBCB9525}" type="datetimeFigureOut">
              <a:rPr kumimoji="1" lang="ja-JP" altLang="en-US" smtClean="0"/>
              <a:t>2023/3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5CE017-24F7-4B62-ADDD-8EE66E8535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31233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9F3930-60C8-401D-9EAA-CF2FBBCB9525}" type="datetimeFigureOut">
              <a:rPr kumimoji="1" lang="ja-JP" altLang="en-US" smtClean="0"/>
              <a:t>2023/3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5CE017-24F7-4B62-ADDD-8EE66E8535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69529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9F3930-60C8-401D-9EAA-CF2FBBCB9525}" type="datetimeFigureOut">
              <a:rPr kumimoji="1" lang="ja-JP" altLang="en-US" smtClean="0"/>
              <a:t>2023/3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5CE017-24F7-4B62-ADDD-8EE66E8535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36716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9F3930-60C8-401D-9EAA-CF2FBBCB9525}" type="datetimeFigureOut">
              <a:rPr kumimoji="1" lang="ja-JP" altLang="en-US" smtClean="0"/>
              <a:t>2023/3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5CE017-24F7-4B62-ADDD-8EE66E8535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27951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3" name="図 62">
            <a:extLst>
              <a:ext uri="{FF2B5EF4-FFF2-40B4-BE49-F238E27FC236}">
                <a16:creationId xmlns:a16="http://schemas.microsoft.com/office/drawing/2014/main" id="{1E7B869B-F2E5-50B7-384B-3F898D9E968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090" t="5107" r="5815" b="11656"/>
          <a:stretch/>
        </p:blipFill>
        <p:spPr>
          <a:xfrm>
            <a:off x="3642901" y="2197920"/>
            <a:ext cx="3167920" cy="2117024"/>
          </a:xfrm>
          <a:prstGeom prst="rect">
            <a:avLst/>
          </a:prstGeom>
        </p:spPr>
      </p:pic>
      <p:pic>
        <p:nvPicPr>
          <p:cNvPr id="59" name="図 58">
            <a:extLst>
              <a:ext uri="{FF2B5EF4-FFF2-40B4-BE49-F238E27FC236}">
                <a16:creationId xmlns:a16="http://schemas.microsoft.com/office/drawing/2014/main" id="{E7291530-55F3-2F84-3978-6562FB51F49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9873" t="7481" r="6123" b="12052"/>
          <a:stretch/>
        </p:blipFill>
        <p:spPr>
          <a:xfrm>
            <a:off x="365694" y="4534030"/>
            <a:ext cx="3087299" cy="2044126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ABF98C49-1EB5-D71C-4588-90DB513FDCF1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7001" t="6081" r="7090" b="12586"/>
          <a:stretch/>
        </p:blipFill>
        <p:spPr>
          <a:xfrm>
            <a:off x="264372" y="2243182"/>
            <a:ext cx="3123175" cy="2043806"/>
          </a:xfrm>
          <a:prstGeom prst="rect">
            <a:avLst/>
          </a:prstGeom>
        </p:spPr>
      </p:pic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79321D6F-14DC-407B-9D1F-8B408A58E9D1}"/>
              </a:ext>
            </a:extLst>
          </p:cNvPr>
          <p:cNvSpPr txBox="1"/>
          <p:nvPr/>
        </p:nvSpPr>
        <p:spPr>
          <a:xfrm rot="10800000">
            <a:off x="29615" y="2753701"/>
            <a:ext cx="340542" cy="961742"/>
          </a:xfrm>
          <a:prstGeom prst="rect">
            <a:avLst/>
          </a:prstGeom>
          <a:solidFill>
            <a:schemeClr val="bg1"/>
          </a:solidFill>
        </p:spPr>
        <p:txBody>
          <a:bodyPr vert="eaVert" wrap="square" rtlCol="0">
            <a:spAutoFit/>
          </a:bodyPr>
          <a:lstStyle/>
          <a:p>
            <a:endParaRPr lang="ja-JP" altLang="en-US" sz="10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7">
            <a:extLst>
              <a:ext uri="{FF2B5EF4-FFF2-40B4-BE49-F238E27FC236}">
                <a16:creationId xmlns:a16="http://schemas.microsoft.com/office/drawing/2014/main" id="{35DFF634-96C1-4056-8171-AC743426A99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49739" y="2906004"/>
            <a:ext cx="961942" cy="21358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788" b="1" dirty="0">
                <a:latin typeface="Times New Roman" pitchFamily="18" charset="0"/>
                <a:cs typeface="Arial" charset="0"/>
              </a:rPr>
              <a:t>L/S</a:t>
            </a:r>
            <a:r>
              <a:rPr lang="ja-JP" altLang="en-US" sz="788" b="1" dirty="0">
                <a:latin typeface="Times New Roman" pitchFamily="18" charset="0"/>
                <a:cs typeface="Arial" charset="0"/>
              </a:rPr>
              <a:t> </a:t>
            </a:r>
            <a:r>
              <a:rPr lang="en-US" altLang="ja-JP" sz="788" b="1" dirty="0">
                <a:latin typeface="Times New Roman" pitchFamily="18" charset="0"/>
                <a:cs typeface="Arial" charset="0"/>
              </a:rPr>
              <a:t>ratio</a:t>
            </a:r>
            <a:r>
              <a:rPr lang="ja-JP" altLang="en-US" sz="788" b="1" dirty="0">
                <a:latin typeface="Times New Roman" pitchFamily="18" charset="0"/>
                <a:cs typeface="Arial" charset="0"/>
              </a:rPr>
              <a:t> </a:t>
            </a:r>
            <a:r>
              <a:rPr lang="en-US" altLang="ja-JP" sz="788" b="1" dirty="0">
                <a:latin typeface="Times New Roman" pitchFamily="18" charset="0"/>
                <a:cs typeface="Arial" charset="0"/>
              </a:rPr>
              <a:t>&lt;</a:t>
            </a:r>
            <a:r>
              <a:rPr lang="ja-JP" altLang="en-US" sz="788" b="1" dirty="0">
                <a:latin typeface="Times New Roman" pitchFamily="18" charset="0"/>
                <a:cs typeface="Arial" charset="0"/>
              </a:rPr>
              <a:t> </a:t>
            </a:r>
            <a:r>
              <a:rPr lang="en-US" altLang="ja-JP" sz="788" b="1" dirty="0">
                <a:latin typeface="Times New Roman" pitchFamily="18" charset="0"/>
                <a:cs typeface="Arial" charset="0"/>
              </a:rPr>
              <a:t>1.268</a:t>
            </a:r>
            <a:endParaRPr lang="ja-JP" altLang="en-US" sz="788" b="1" dirty="0">
              <a:latin typeface="Times New Roman" pitchFamily="18" charset="0"/>
              <a:cs typeface="Arial" charset="0"/>
            </a:endParaRPr>
          </a:p>
        </p:txBody>
      </p:sp>
      <p:sp>
        <p:nvSpPr>
          <p:cNvPr id="26" name="テキスト ボックス 9">
            <a:extLst>
              <a:ext uri="{FF2B5EF4-FFF2-40B4-BE49-F238E27FC236}">
                <a16:creationId xmlns:a16="http://schemas.microsoft.com/office/drawing/2014/main" id="{834BE626-D0C8-4FF1-9815-8CB0FB731A3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57144" y="3042847"/>
            <a:ext cx="543648" cy="21358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788" b="1" dirty="0">
                <a:latin typeface="Times New Roman" pitchFamily="18" charset="0"/>
                <a:cs typeface="Arial" charset="0"/>
              </a:rPr>
              <a:t>n = 109 </a:t>
            </a:r>
            <a:endParaRPr lang="ja-JP" altLang="en-US" sz="788" b="1" dirty="0">
              <a:latin typeface="Times New Roman" pitchFamily="18" charset="0"/>
              <a:cs typeface="Arial" charset="0"/>
            </a:endParaRPr>
          </a:p>
        </p:txBody>
      </p:sp>
      <p:sp>
        <p:nvSpPr>
          <p:cNvPr id="29" name="テキスト ボックス 6">
            <a:extLst>
              <a:ext uri="{FF2B5EF4-FFF2-40B4-BE49-F238E27FC236}">
                <a16:creationId xmlns:a16="http://schemas.microsoft.com/office/drawing/2014/main" id="{845A64FE-B849-4B62-A492-94E374C27CC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39857" y="3550975"/>
            <a:ext cx="983135" cy="36946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1013" b="1" i="1" dirty="0">
                <a:latin typeface="Times New Roman" pitchFamily="18" charset="0"/>
                <a:cs typeface="Arial" charset="0"/>
              </a:rPr>
              <a:t>P</a:t>
            </a:r>
            <a:r>
              <a:rPr lang="en-US" altLang="ja-JP" sz="1013" b="1" dirty="0">
                <a:latin typeface="Times New Roman" pitchFamily="18" charset="0"/>
                <a:cs typeface="Arial" charset="0"/>
              </a:rPr>
              <a:t> = 0.208</a:t>
            </a:r>
          </a:p>
          <a:p>
            <a:r>
              <a:rPr lang="en-US" altLang="ja-JP" sz="788" b="1" dirty="0">
                <a:latin typeface="Times New Roman" pitchFamily="18" charset="0"/>
                <a:cs typeface="Arial" charset="0"/>
              </a:rPr>
              <a:t>Log rank test</a:t>
            </a:r>
            <a:endParaRPr lang="ja-JP" altLang="en-US" sz="788" b="1" dirty="0">
              <a:latin typeface="Times New Roman" pitchFamily="18" charset="0"/>
              <a:cs typeface="Arial" charset="0"/>
            </a:endParaRP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B7152FE5-B738-4C17-8C06-050F79EF6DC4}"/>
              </a:ext>
            </a:extLst>
          </p:cNvPr>
          <p:cNvGrpSpPr/>
          <p:nvPr/>
        </p:nvGrpSpPr>
        <p:grpSpPr>
          <a:xfrm>
            <a:off x="235663" y="4269683"/>
            <a:ext cx="3131333" cy="263953"/>
            <a:chOff x="659024" y="4828378"/>
            <a:chExt cx="5436975" cy="696387"/>
          </a:xfrm>
        </p:grpSpPr>
        <p:sp>
          <p:nvSpPr>
            <p:cNvPr id="20" name="テキスト ボックス 7">
              <a:extLst>
                <a:ext uri="{FF2B5EF4-FFF2-40B4-BE49-F238E27FC236}">
                  <a16:creationId xmlns:a16="http://schemas.microsoft.com/office/drawing/2014/main" id="{51807FFC-B71B-47AA-9EF7-8A78B4AEA59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59024" y="4898837"/>
              <a:ext cx="5341571" cy="625928"/>
            </a:xfrm>
            <a:prstGeom prst="rect">
              <a:avLst/>
            </a:prstGeom>
            <a:solidFill>
              <a:schemeClr val="bg1"/>
            </a:solidFill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endParaRPr lang="en-US" altLang="ja-JP" sz="900" b="1" dirty="0">
                <a:latin typeface="Times New Roman" pitchFamily="18" charset="0"/>
                <a:cs typeface="Arial" charset="0"/>
              </a:endParaRPr>
            </a:p>
            <a:p>
              <a:endParaRPr lang="ja-JP" altLang="en-US" sz="788" b="1" dirty="0">
                <a:latin typeface="Times New Roman" pitchFamily="18" charset="0"/>
                <a:cs typeface="Arial" charset="0"/>
              </a:endParaRPr>
            </a:p>
          </p:txBody>
        </p:sp>
        <p:sp>
          <p:nvSpPr>
            <p:cNvPr id="23" name="テキスト ボックス 7">
              <a:extLst>
                <a:ext uri="{FF2B5EF4-FFF2-40B4-BE49-F238E27FC236}">
                  <a16:creationId xmlns:a16="http://schemas.microsoft.com/office/drawing/2014/main" id="{6F071C56-5DD5-4BBB-B14E-CD2D75B7B47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88670" y="4828378"/>
              <a:ext cx="5007329" cy="43772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imes</a:t>
              </a:r>
              <a:r>
                <a:rPr lang="ja-JP" alt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ja-JP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fter</a:t>
              </a:r>
              <a:r>
                <a:rPr lang="ja-JP" alt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ja-JP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rgery</a:t>
              </a:r>
              <a:r>
                <a:rPr lang="ja-JP" alt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ja-JP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years)</a:t>
              </a:r>
              <a:endParaRPr lang="ja-JP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D262662E-F6DA-46C4-B78A-7F59559B099E}"/>
              </a:ext>
            </a:extLst>
          </p:cNvPr>
          <p:cNvSpPr txBox="1"/>
          <p:nvPr/>
        </p:nvSpPr>
        <p:spPr>
          <a:xfrm rot="10800000">
            <a:off x="3222239" y="2594097"/>
            <a:ext cx="340542" cy="1174380"/>
          </a:xfrm>
          <a:prstGeom prst="rect">
            <a:avLst/>
          </a:prstGeom>
          <a:solidFill>
            <a:schemeClr val="bg1"/>
          </a:solidFill>
        </p:spPr>
        <p:txBody>
          <a:bodyPr vert="eaVert" wrap="square" rtlCol="0">
            <a:spAutoFit/>
          </a:bodyPr>
          <a:lstStyle/>
          <a:p>
            <a:endParaRPr lang="ja-JP" altLang="en-US" sz="10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280D40BE-DFF7-40D3-A52A-E4E90C057E47}"/>
              </a:ext>
            </a:extLst>
          </p:cNvPr>
          <p:cNvSpPr txBox="1"/>
          <p:nvPr/>
        </p:nvSpPr>
        <p:spPr>
          <a:xfrm rot="10800000">
            <a:off x="3416397" y="2397738"/>
            <a:ext cx="340542" cy="149622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ja-JP" sz="101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ease free survival rate</a:t>
            </a:r>
            <a:endParaRPr lang="ja-JP" altLang="en-US" sz="1013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テキスト ボックス 7">
            <a:extLst>
              <a:ext uri="{FF2B5EF4-FFF2-40B4-BE49-F238E27FC236}">
                <a16:creationId xmlns:a16="http://schemas.microsoft.com/office/drawing/2014/main" id="{FC083BB5-3BC3-27C9-CD7D-9861ECFD271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87597" y="4269683"/>
            <a:ext cx="288388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s</a:t>
            </a:r>
            <a:r>
              <a:rPr lang="ja-JP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fter</a:t>
            </a:r>
            <a:r>
              <a:rPr lang="ja-JP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rgery</a:t>
            </a:r>
            <a:r>
              <a:rPr lang="ja-JP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years)</a:t>
            </a:r>
            <a:endParaRPr lang="ja-JP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7">
            <a:extLst>
              <a:ext uri="{FF2B5EF4-FFF2-40B4-BE49-F238E27FC236}">
                <a16:creationId xmlns:a16="http://schemas.microsoft.com/office/drawing/2014/main" id="{92FC807B-950C-5472-705B-C09291DC4B2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45665" y="2361860"/>
            <a:ext cx="961942" cy="21358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788" b="1" dirty="0">
                <a:latin typeface="Times New Roman" pitchFamily="18" charset="0"/>
                <a:cs typeface="Arial" charset="0"/>
              </a:rPr>
              <a:t>L/S</a:t>
            </a:r>
            <a:r>
              <a:rPr lang="ja-JP" altLang="en-US" sz="788" b="1" dirty="0">
                <a:latin typeface="Times New Roman" pitchFamily="18" charset="0"/>
                <a:cs typeface="Arial" charset="0"/>
              </a:rPr>
              <a:t> </a:t>
            </a:r>
            <a:r>
              <a:rPr lang="en-US" altLang="ja-JP" sz="788" b="1" dirty="0">
                <a:latin typeface="Times New Roman" pitchFamily="18" charset="0"/>
                <a:cs typeface="Arial" charset="0"/>
              </a:rPr>
              <a:t>ratio</a:t>
            </a:r>
            <a:r>
              <a:rPr lang="ja-JP" altLang="en-US" sz="788" b="1" dirty="0">
                <a:latin typeface="Times New Roman" pitchFamily="18" charset="0"/>
                <a:cs typeface="Arial" charset="0"/>
              </a:rPr>
              <a:t> </a:t>
            </a:r>
            <a:r>
              <a:rPr lang="ja-JP" altLang="en-US" sz="788" b="1" u="sng" dirty="0">
                <a:latin typeface="Times New Roman" pitchFamily="18" charset="0"/>
                <a:cs typeface="Arial" charset="0"/>
              </a:rPr>
              <a:t>≥</a:t>
            </a:r>
            <a:r>
              <a:rPr lang="ja-JP" altLang="en-US" sz="788" b="1" dirty="0">
                <a:latin typeface="Times New Roman" pitchFamily="18" charset="0"/>
                <a:cs typeface="Arial" charset="0"/>
              </a:rPr>
              <a:t> </a:t>
            </a:r>
            <a:r>
              <a:rPr lang="en-US" altLang="ja-JP" sz="788" b="1" dirty="0">
                <a:latin typeface="Times New Roman" pitchFamily="18" charset="0"/>
                <a:cs typeface="Arial" charset="0"/>
              </a:rPr>
              <a:t>1.268</a:t>
            </a:r>
            <a:endParaRPr lang="ja-JP" altLang="en-US" sz="788" b="1" dirty="0">
              <a:latin typeface="Times New Roman" pitchFamily="18" charset="0"/>
              <a:cs typeface="Arial" charset="0"/>
            </a:endParaRPr>
          </a:p>
        </p:txBody>
      </p:sp>
      <p:sp>
        <p:nvSpPr>
          <p:cNvPr id="8" name="テキスト ボックス 9">
            <a:extLst>
              <a:ext uri="{FF2B5EF4-FFF2-40B4-BE49-F238E27FC236}">
                <a16:creationId xmlns:a16="http://schemas.microsoft.com/office/drawing/2014/main" id="{B88FF316-CF52-3480-1763-2635194FB4C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53069" y="2498703"/>
            <a:ext cx="621303" cy="21358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788" b="1" dirty="0">
                <a:latin typeface="Times New Roman" pitchFamily="18" charset="0"/>
                <a:cs typeface="Arial" charset="0"/>
              </a:rPr>
              <a:t>n = 140 </a:t>
            </a:r>
            <a:endParaRPr lang="ja-JP" altLang="en-US" sz="788" b="1" dirty="0">
              <a:latin typeface="Times New Roman" pitchFamily="18" charset="0"/>
              <a:cs typeface="Arial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656B29DA-820F-4591-2C9D-18B963891B32}"/>
              </a:ext>
            </a:extLst>
          </p:cNvPr>
          <p:cNvSpPr txBox="1"/>
          <p:nvPr/>
        </p:nvSpPr>
        <p:spPr>
          <a:xfrm rot="10800000">
            <a:off x="89302" y="2337257"/>
            <a:ext cx="340542" cy="1558418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ja-JP" sz="101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ease free survival rate</a:t>
            </a:r>
            <a:endParaRPr lang="ja-JP" altLang="en-US" sz="1013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9">
            <a:extLst>
              <a:ext uri="{FF2B5EF4-FFF2-40B4-BE49-F238E27FC236}">
                <a16:creationId xmlns:a16="http://schemas.microsoft.com/office/drawing/2014/main" id="{662FDB66-065E-F780-B68C-9394AF9F923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97488" y="2511785"/>
            <a:ext cx="582451" cy="21358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788" b="1" dirty="0">
                <a:latin typeface="Times New Roman" pitchFamily="18" charset="0"/>
                <a:cs typeface="Arial" charset="0"/>
              </a:rPr>
              <a:t>n = 140</a:t>
            </a:r>
            <a:endParaRPr lang="ja-JP" altLang="en-US" sz="788" b="1" dirty="0">
              <a:latin typeface="Times New Roman" pitchFamily="18" charset="0"/>
              <a:cs typeface="Arial" charset="0"/>
            </a:endParaRPr>
          </a:p>
        </p:txBody>
      </p:sp>
      <p:sp>
        <p:nvSpPr>
          <p:cNvPr id="30" name="テキスト ボックス 7">
            <a:extLst>
              <a:ext uri="{FF2B5EF4-FFF2-40B4-BE49-F238E27FC236}">
                <a16:creationId xmlns:a16="http://schemas.microsoft.com/office/drawing/2014/main" id="{B5509892-082D-9318-F728-74A102B04B8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29815" y="2386416"/>
            <a:ext cx="1528185" cy="21358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788" b="1" dirty="0">
                <a:latin typeface="Times New Roman" pitchFamily="18" charset="0"/>
                <a:cs typeface="Arial" charset="0"/>
              </a:rPr>
              <a:t>ALBI score &lt;</a:t>
            </a:r>
            <a:r>
              <a:rPr lang="ja-JP" altLang="en-US" sz="788" b="1" dirty="0">
                <a:latin typeface="Times New Roman" pitchFamily="18" charset="0"/>
                <a:cs typeface="Arial" charset="0"/>
              </a:rPr>
              <a:t> </a:t>
            </a:r>
            <a:r>
              <a:rPr lang="en-US" altLang="ja-JP" sz="788" b="1" dirty="0">
                <a:latin typeface="Times New Roman" pitchFamily="18" charset="0"/>
                <a:cs typeface="Arial" charset="0"/>
              </a:rPr>
              <a:t>-2.6</a:t>
            </a:r>
            <a:endParaRPr lang="ja-JP" altLang="en-US" sz="788" b="1" dirty="0">
              <a:latin typeface="Times New Roman" pitchFamily="18" charset="0"/>
              <a:cs typeface="Arial" charset="0"/>
            </a:endParaRPr>
          </a:p>
        </p:txBody>
      </p:sp>
      <p:pic>
        <p:nvPicPr>
          <p:cNvPr id="31" name="図 30">
            <a:extLst>
              <a:ext uri="{FF2B5EF4-FFF2-40B4-BE49-F238E27FC236}">
                <a16:creationId xmlns:a16="http://schemas.microsoft.com/office/drawing/2014/main" id="{603AE1C6-2696-F15E-6FCF-6739FDA3178F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7921" t="5992" r="5544" b="12583"/>
          <a:stretch/>
        </p:blipFill>
        <p:spPr>
          <a:xfrm>
            <a:off x="3642901" y="4504932"/>
            <a:ext cx="3142392" cy="2043806"/>
          </a:xfrm>
          <a:prstGeom prst="rect">
            <a:avLst/>
          </a:prstGeom>
        </p:spPr>
      </p:pic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533C8474-CC33-F98B-6BB1-B22EA7A9B6DC}"/>
              </a:ext>
            </a:extLst>
          </p:cNvPr>
          <p:cNvSpPr txBox="1"/>
          <p:nvPr/>
        </p:nvSpPr>
        <p:spPr>
          <a:xfrm rot="10800000">
            <a:off x="15759" y="5015451"/>
            <a:ext cx="340542" cy="961742"/>
          </a:xfrm>
          <a:prstGeom prst="rect">
            <a:avLst/>
          </a:prstGeom>
          <a:solidFill>
            <a:schemeClr val="bg1"/>
          </a:solidFill>
        </p:spPr>
        <p:txBody>
          <a:bodyPr vert="eaVert" wrap="square" rtlCol="0">
            <a:spAutoFit/>
          </a:bodyPr>
          <a:lstStyle/>
          <a:p>
            <a:endParaRPr lang="ja-JP" altLang="en-US" sz="10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テキスト ボックス 7">
            <a:extLst>
              <a:ext uri="{FF2B5EF4-FFF2-40B4-BE49-F238E27FC236}">
                <a16:creationId xmlns:a16="http://schemas.microsoft.com/office/drawing/2014/main" id="{F325755C-8B94-AAD7-A684-17D8EF9574D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35883" y="5105408"/>
            <a:ext cx="961942" cy="21358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788" b="1" dirty="0">
                <a:latin typeface="Times New Roman" pitchFamily="18" charset="0"/>
                <a:cs typeface="Arial" charset="0"/>
              </a:rPr>
              <a:t>L/S</a:t>
            </a:r>
            <a:r>
              <a:rPr lang="ja-JP" altLang="en-US" sz="788" b="1" dirty="0">
                <a:latin typeface="Times New Roman" pitchFamily="18" charset="0"/>
                <a:cs typeface="Arial" charset="0"/>
              </a:rPr>
              <a:t> </a:t>
            </a:r>
            <a:r>
              <a:rPr lang="en-US" altLang="ja-JP" sz="788" b="1" dirty="0">
                <a:latin typeface="Times New Roman" pitchFamily="18" charset="0"/>
                <a:cs typeface="Arial" charset="0"/>
              </a:rPr>
              <a:t>ratio</a:t>
            </a:r>
            <a:r>
              <a:rPr lang="ja-JP" altLang="en-US" sz="788" b="1" dirty="0">
                <a:latin typeface="Times New Roman" pitchFamily="18" charset="0"/>
                <a:cs typeface="Arial" charset="0"/>
              </a:rPr>
              <a:t> </a:t>
            </a:r>
            <a:r>
              <a:rPr lang="en-US" altLang="ja-JP" sz="788" b="1" dirty="0">
                <a:latin typeface="Times New Roman" pitchFamily="18" charset="0"/>
                <a:cs typeface="Arial" charset="0"/>
              </a:rPr>
              <a:t>&lt;</a:t>
            </a:r>
            <a:r>
              <a:rPr lang="ja-JP" altLang="en-US" sz="788" b="1" dirty="0">
                <a:latin typeface="Times New Roman" pitchFamily="18" charset="0"/>
                <a:cs typeface="Arial" charset="0"/>
              </a:rPr>
              <a:t> </a:t>
            </a:r>
            <a:r>
              <a:rPr lang="en-US" altLang="ja-JP" sz="788" b="1" dirty="0">
                <a:latin typeface="Times New Roman" pitchFamily="18" charset="0"/>
                <a:cs typeface="Arial" charset="0"/>
              </a:rPr>
              <a:t>1.3</a:t>
            </a:r>
            <a:endParaRPr lang="ja-JP" altLang="en-US" sz="788" b="1" dirty="0">
              <a:latin typeface="Times New Roman" pitchFamily="18" charset="0"/>
              <a:cs typeface="Arial" charset="0"/>
            </a:endParaRPr>
          </a:p>
        </p:txBody>
      </p:sp>
      <p:sp>
        <p:nvSpPr>
          <p:cNvPr id="40" name="テキスト ボックス 9">
            <a:extLst>
              <a:ext uri="{FF2B5EF4-FFF2-40B4-BE49-F238E27FC236}">
                <a16:creationId xmlns:a16="http://schemas.microsoft.com/office/drawing/2014/main" id="{6E7B23ED-C619-F45E-99FF-FB91A461D57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43287" y="5242251"/>
            <a:ext cx="552033" cy="21358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788" b="1" dirty="0">
                <a:latin typeface="Times New Roman" pitchFamily="18" charset="0"/>
                <a:cs typeface="Arial" charset="0"/>
              </a:rPr>
              <a:t>n = 116 </a:t>
            </a:r>
            <a:endParaRPr lang="ja-JP" altLang="en-US" sz="788" b="1" dirty="0">
              <a:latin typeface="Times New Roman" pitchFamily="18" charset="0"/>
              <a:cs typeface="Arial" charset="0"/>
            </a:endParaRPr>
          </a:p>
        </p:txBody>
      </p:sp>
      <p:sp>
        <p:nvSpPr>
          <p:cNvPr id="41" name="テキスト ボックス 6">
            <a:extLst>
              <a:ext uri="{FF2B5EF4-FFF2-40B4-BE49-F238E27FC236}">
                <a16:creationId xmlns:a16="http://schemas.microsoft.com/office/drawing/2014/main" id="{D774674C-0D1F-FF24-FCA6-7E8E9627C9E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26001" y="5812725"/>
            <a:ext cx="983135" cy="36946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1013" b="1" i="1" dirty="0">
                <a:latin typeface="Times New Roman" pitchFamily="18" charset="0"/>
                <a:cs typeface="Arial" charset="0"/>
              </a:rPr>
              <a:t>P</a:t>
            </a:r>
            <a:r>
              <a:rPr lang="en-US" altLang="ja-JP" sz="1013" b="1" dirty="0">
                <a:latin typeface="Times New Roman" pitchFamily="18" charset="0"/>
                <a:cs typeface="Arial" charset="0"/>
              </a:rPr>
              <a:t> = 0.273</a:t>
            </a:r>
          </a:p>
          <a:p>
            <a:r>
              <a:rPr lang="en-US" altLang="ja-JP" sz="788" b="1" dirty="0">
                <a:latin typeface="Times New Roman" pitchFamily="18" charset="0"/>
                <a:cs typeface="Arial" charset="0"/>
              </a:rPr>
              <a:t>Log rank test</a:t>
            </a:r>
            <a:endParaRPr lang="ja-JP" altLang="en-US" sz="788" b="1" dirty="0">
              <a:latin typeface="Times New Roman" pitchFamily="18" charset="0"/>
              <a:cs typeface="Arial" charset="0"/>
            </a:endParaRPr>
          </a:p>
        </p:txBody>
      </p:sp>
      <p:grpSp>
        <p:nvGrpSpPr>
          <p:cNvPr id="42" name="グループ化 41">
            <a:extLst>
              <a:ext uri="{FF2B5EF4-FFF2-40B4-BE49-F238E27FC236}">
                <a16:creationId xmlns:a16="http://schemas.microsoft.com/office/drawing/2014/main" id="{2B18BE4E-694F-854B-EAF1-145AD7D58029}"/>
              </a:ext>
            </a:extLst>
          </p:cNvPr>
          <p:cNvGrpSpPr/>
          <p:nvPr/>
        </p:nvGrpSpPr>
        <p:grpSpPr>
          <a:xfrm>
            <a:off x="221807" y="6531433"/>
            <a:ext cx="3131333" cy="391717"/>
            <a:chOff x="659024" y="4828378"/>
            <a:chExt cx="5436975" cy="696387"/>
          </a:xfrm>
        </p:grpSpPr>
        <p:sp>
          <p:nvSpPr>
            <p:cNvPr id="43" name="テキスト ボックス 7">
              <a:extLst>
                <a:ext uri="{FF2B5EF4-FFF2-40B4-BE49-F238E27FC236}">
                  <a16:creationId xmlns:a16="http://schemas.microsoft.com/office/drawing/2014/main" id="{9C06038D-58C9-862D-9C08-6B87A0390B9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59024" y="4898837"/>
              <a:ext cx="5341571" cy="625928"/>
            </a:xfrm>
            <a:prstGeom prst="rect">
              <a:avLst/>
            </a:prstGeom>
            <a:solidFill>
              <a:schemeClr val="bg1"/>
            </a:solidFill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endParaRPr lang="en-US" altLang="ja-JP" sz="900" b="1" dirty="0">
                <a:latin typeface="Times New Roman" pitchFamily="18" charset="0"/>
                <a:cs typeface="Arial" charset="0"/>
              </a:endParaRPr>
            </a:p>
            <a:p>
              <a:endParaRPr lang="ja-JP" altLang="en-US" sz="788" b="1" dirty="0">
                <a:latin typeface="Times New Roman" pitchFamily="18" charset="0"/>
                <a:cs typeface="Arial" charset="0"/>
              </a:endParaRPr>
            </a:p>
          </p:txBody>
        </p:sp>
        <p:sp>
          <p:nvSpPr>
            <p:cNvPr id="44" name="テキスト ボックス 7">
              <a:extLst>
                <a:ext uri="{FF2B5EF4-FFF2-40B4-BE49-F238E27FC236}">
                  <a16:creationId xmlns:a16="http://schemas.microsoft.com/office/drawing/2014/main" id="{E08AABA4-2088-8F5E-2AE1-558AE0CBA7B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88670" y="4828378"/>
              <a:ext cx="5007329" cy="43772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imes</a:t>
              </a:r>
              <a:r>
                <a:rPr lang="ja-JP" alt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ja-JP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fter</a:t>
              </a:r>
              <a:r>
                <a:rPr lang="ja-JP" alt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ja-JP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rgery</a:t>
              </a:r>
              <a:r>
                <a:rPr lang="ja-JP" alt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ja-JP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years)</a:t>
              </a:r>
              <a:endParaRPr lang="ja-JP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98877F21-3D68-0D97-C3C9-D9E6B02FA504}"/>
              </a:ext>
            </a:extLst>
          </p:cNvPr>
          <p:cNvSpPr txBox="1"/>
          <p:nvPr/>
        </p:nvSpPr>
        <p:spPr>
          <a:xfrm rot="10800000">
            <a:off x="3208383" y="4855847"/>
            <a:ext cx="340542" cy="1174380"/>
          </a:xfrm>
          <a:prstGeom prst="rect">
            <a:avLst/>
          </a:prstGeom>
          <a:solidFill>
            <a:schemeClr val="bg1"/>
          </a:solidFill>
        </p:spPr>
        <p:txBody>
          <a:bodyPr vert="eaVert" wrap="square" rtlCol="0">
            <a:spAutoFit/>
          </a:bodyPr>
          <a:lstStyle/>
          <a:p>
            <a:endParaRPr lang="ja-JP" altLang="en-US" sz="10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E5C49CAE-7298-ADC0-C144-FF6AC9572076}"/>
              </a:ext>
            </a:extLst>
          </p:cNvPr>
          <p:cNvSpPr txBox="1"/>
          <p:nvPr/>
        </p:nvSpPr>
        <p:spPr>
          <a:xfrm rot="10800000">
            <a:off x="3415789" y="4659488"/>
            <a:ext cx="340542" cy="149622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ja-JP" sz="101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ease free survival rate</a:t>
            </a:r>
            <a:endParaRPr lang="ja-JP" altLang="en-US" sz="1013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テキスト ボックス 7">
            <a:extLst>
              <a:ext uri="{FF2B5EF4-FFF2-40B4-BE49-F238E27FC236}">
                <a16:creationId xmlns:a16="http://schemas.microsoft.com/office/drawing/2014/main" id="{5583FA9C-EC15-2856-CEDF-1213E723FDE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73741" y="6531433"/>
            <a:ext cx="288388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s</a:t>
            </a:r>
            <a:r>
              <a:rPr lang="ja-JP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fter</a:t>
            </a:r>
            <a:r>
              <a:rPr lang="ja-JP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rgery</a:t>
            </a:r>
            <a:r>
              <a:rPr lang="ja-JP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years)</a:t>
            </a:r>
            <a:endParaRPr lang="ja-JP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テキスト ボックス 7">
            <a:extLst>
              <a:ext uri="{FF2B5EF4-FFF2-40B4-BE49-F238E27FC236}">
                <a16:creationId xmlns:a16="http://schemas.microsoft.com/office/drawing/2014/main" id="{92EDF058-6A9F-17CE-B926-646EC33BA94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31808" y="4654783"/>
            <a:ext cx="1177327" cy="21358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788" b="1" dirty="0">
                <a:latin typeface="Times New Roman" pitchFamily="18" charset="0"/>
                <a:cs typeface="Arial" charset="0"/>
              </a:rPr>
              <a:t>FIB-4 index</a:t>
            </a:r>
            <a:r>
              <a:rPr lang="ja-JP" altLang="en-US" sz="788" b="1" dirty="0">
                <a:latin typeface="Times New Roman" pitchFamily="18" charset="0"/>
                <a:cs typeface="Arial" charset="0"/>
              </a:rPr>
              <a:t> </a:t>
            </a:r>
            <a:r>
              <a:rPr lang="ja-JP" altLang="en-US" sz="788" b="1" u="sng" dirty="0">
                <a:latin typeface="Times New Roman" pitchFamily="18" charset="0"/>
                <a:cs typeface="Arial" charset="0"/>
              </a:rPr>
              <a:t>≥</a:t>
            </a:r>
            <a:r>
              <a:rPr lang="ja-JP" altLang="en-US" sz="788" b="1" dirty="0">
                <a:latin typeface="Times New Roman" pitchFamily="18" charset="0"/>
                <a:cs typeface="Arial" charset="0"/>
              </a:rPr>
              <a:t> </a:t>
            </a:r>
            <a:r>
              <a:rPr lang="en-US" altLang="ja-JP" sz="788" b="1" dirty="0">
                <a:latin typeface="Times New Roman" pitchFamily="18" charset="0"/>
                <a:cs typeface="Arial" charset="0"/>
              </a:rPr>
              <a:t>1.3</a:t>
            </a:r>
            <a:endParaRPr lang="ja-JP" altLang="en-US" sz="788" b="1" dirty="0">
              <a:latin typeface="Times New Roman" pitchFamily="18" charset="0"/>
              <a:cs typeface="Arial" charset="0"/>
            </a:endParaRPr>
          </a:p>
        </p:txBody>
      </p:sp>
      <p:sp>
        <p:nvSpPr>
          <p:cNvPr id="50" name="テキスト ボックス 9">
            <a:extLst>
              <a:ext uri="{FF2B5EF4-FFF2-40B4-BE49-F238E27FC236}">
                <a16:creationId xmlns:a16="http://schemas.microsoft.com/office/drawing/2014/main" id="{C058A824-4C71-63C0-B6C5-684A1B9C8F2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39214" y="4760453"/>
            <a:ext cx="635158" cy="21358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788" b="1" dirty="0">
                <a:latin typeface="Times New Roman" pitchFamily="18" charset="0"/>
                <a:cs typeface="Arial" charset="0"/>
              </a:rPr>
              <a:t>n = 133 </a:t>
            </a:r>
            <a:endParaRPr lang="ja-JP" altLang="en-US" sz="788" b="1" dirty="0">
              <a:latin typeface="Times New Roman" pitchFamily="18" charset="0"/>
              <a:cs typeface="Arial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F3A43702-0324-00B9-C2B5-6F0261A9B54A}"/>
              </a:ext>
            </a:extLst>
          </p:cNvPr>
          <p:cNvSpPr txBox="1"/>
          <p:nvPr/>
        </p:nvSpPr>
        <p:spPr>
          <a:xfrm rot="10800000">
            <a:off x="46184" y="4660834"/>
            <a:ext cx="340542" cy="149622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ja-JP" sz="101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ease free survival rate</a:t>
            </a:r>
            <a:endParaRPr lang="ja-JP" altLang="en-US" sz="1013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テキスト ボックス 7">
            <a:extLst>
              <a:ext uri="{FF2B5EF4-FFF2-40B4-BE49-F238E27FC236}">
                <a16:creationId xmlns:a16="http://schemas.microsoft.com/office/drawing/2014/main" id="{E88E9D10-5368-1F99-3D3C-C844EDCFC82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26352" y="5099333"/>
            <a:ext cx="1528185" cy="21358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788" b="1" dirty="0">
                <a:latin typeface="Times New Roman" pitchFamily="18" charset="0"/>
                <a:cs typeface="Arial" charset="0"/>
              </a:rPr>
              <a:t>Hepatic</a:t>
            </a:r>
            <a:r>
              <a:rPr lang="ja-JP" altLang="en-US" sz="788" b="1" dirty="0">
                <a:latin typeface="Times New Roman" pitchFamily="18" charset="0"/>
                <a:cs typeface="Arial" charset="0"/>
              </a:rPr>
              <a:t> </a:t>
            </a:r>
            <a:r>
              <a:rPr lang="en-US" altLang="ja-JP" sz="788" b="1" dirty="0">
                <a:latin typeface="Times New Roman" pitchFamily="18" charset="0"/>
                <a:cs typeface="Arial" charset="0"/>
              </a:rPr>
              <a:t>stenosis</a:t>
            </a:r>
            <a:r>
              <a:rPr lang="ja-JP" altLang="en-US" sz="788" b="1" dirty="0">
                <a:latin typeface="Times New Roman" pitchFamily="18" charset="0"/>
                <a:cs typeface="Arial" charset="0"/>
              </a:rPr>
              <a:t> </a:t>
            </a:r>
            <a:r>
              <a:rPr lang="en-US" altLang="ja-JP" sz="788" b="1" dirty="0">
                <a:latin typeface="Times New Roman" pitchFamily="18" charset="0"/>
                <a:cs typeface="Arial" charset="0"/>
              </a:rPr>
              <a:t>index</a:t>
            </a:r>
            <a:r>
              <a:rPr lang="ja-JP" altLang="en-US" sz="788" b="1" dirty="0">
                <a:latin typeface="Times New Roman" pitchFamily="18" charset="0"/>
                <a:cs typeface="Arial" charset="0"/>
              </a:rPr>
              <a:t> ≥ </a:t>
            </a:r>
            <a:r>
              <a:rPr lang="en-US" altLang="ja-JP" sz="788" b="1" dirty="0">
                <a:latin typeface="Times New Roman" pitchFamily="18" charset="0"/>
                <a:cs typeface="Arial" charset="0"/>
              </a:rPr>
              <a:t>30</a:t>
            </a:r>
            <a:endParaRPr lang="ja-JP" altLang="en-US" sz="788" b="1" dirty="0">
              <a:latin typeface="Times New Roman" pitchFamily="18" charset="0"/>
              <a:cs typeface="Arial" charset="0"/>
            </a:endParaRPr>
          </a:p>
        </p:txBody>
      </p:sp>
      <p:sp>
        <p:nvSpPr>
          <p:cNvPr id="55" name="テキスト ボックス 9">
            <a:extLst>
              <a:ext uri="{FF2B5EF4-FFF2-40B4-BE49-F238E27FC236}">
                <a16:creationId xmlns:a16="http://schemas.microsoft.com/office/drawing/2014/main" id="{E43D13F3-E491-6001-9A62-3914F2ED783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59789" y="5236176"/>
            <a:ext cx="496418" cy="21358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788" b="1" dirty="0">
                <a:latin typeface="Times New Roman" pitchFamily="18" charset="0"/>
                <a:cs typeface="Arial" charset="0"/>
              </a:rPr>
              <a:t>n = 44 </a:t>
            </a:r>
            <a:endParaRPr lang="ja-JP" altLang="en-US" sz="788" b="1" dirty="0">
              <a:latin typeface="Times New Roman" pitchFamily="18" charset="0"/>
              <a:cs typeface="Arial" charset="0"/>
            </a:endParaRPr>
          </a:p>
        </p:txBody>
      </p:sp>
      <p:sp>
        <p:nvSpPr>
          <p:cNvPr id="56" name="テキスト ボックス 9">
            <a:extLst>
              <a:ext uri="{FF2B5EF4-FFF2-40B4-BE49-F238E27FC236}">
                <a16:creationId xmlns:a16="http://schemas.microsoft.com/office/drawing/2014/main" id="{36E37D0B-E474-02AE-FC07-804238EB142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37175" y="4835614"/>
            <a:ext cx="634307" cy="21358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788" b="1" dirty="0">
                <a:latin typeface="Times New Roman" pitchFamily="18" charset="0"/>
                <a:cs typeface="Arial" charset="0"/>
              </a:rPr>
              <a:t>n =  205</a:t>
            </a:r>
            <a:endParaRPr lang="ja-JP" altLang="en-US" sz="788" b="1" dirty="0">
              <a:latin typeface="Times New Roman" pitchFamily="18" charset="0"/>
              <a:cs typeface="Arial" charset="0"/>
            </a:endParaRPr>
          </a:p>
        </p:txBody>
      </p:sp>
      <p:sp>
        <p:nvSpPr>
          <p:cNvPr id="57" name="テキスト ボックス 7">
            <a:extLst>
              <a:ext uri="{FF2B5EF4-FFF2-40B4-BE49-F238E27FC236}">
                <a16:creationId xmlns:a16="http://schemas.microsoft.com/office/drawing/2014/main" id="{ADBD615E-A3C5-3B79-583F-B6DAE645494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15959" y="4700121"/>
            <a:ext cx="1528185" cy="21358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788" b="1" dirty="0">
                <a:latin typeface="Times New Roman" pitchFamily="18" charset="0"/>
                <a:cs typeface="Arial" charset="0"/>
              </a:rPr>
              <a:t>Hepatic</a:t>
            </a:r>
            <a:r>
              <a:rPr lang="ja-JP" altLang="en-US" sz="788" b="1" dirty="0">
                <a:latin typeface="Times New Roman" pitchFamily="18" charset="0"/>
                <a:cs typeface="Arial" charset="0"/>
              </a:rPr>
              <a:t> </a:t>
            </a:r>
            <a:r>
              <a:rPr lang="en-US" altLang="ja-JP" sz="788" b="1" dirty="0">
                <a:latin typeface="Times New Roman" pitchFamily="18" charset="0"/>
                <a:cs typeface="Arial" charset="0"/>
              </a:rPr>
              <a:t>stenosis</a:t>
            </a:r>
            <a:r>
              <a:rPr lang="ja-JP" altLang="en-US" sz="788" b="1" dirty="0">
                <a:latin typeface="Times New Roman" pitchFamily="18" charset="0"/>
                <a:cs typeface="Arial" charset="0"/>
              </a:rPr>
              <a:t> </a:t>
            </a:r>
            <a:r>
              <a:rPr lang="en-US" altLang="ja-JP" sz="788" b="1" dirty="0">
                <a:latin typeface="Times New Roman" pitchFamily="18" charset="0"/>
                <a:cs typeface="Arial" charset="0"/>
              </a:rPr>
              <a:t>index</a:t>
            </a:r>
            <a:r>
              <a:rPr lang="ja-JP" altLang="en-US" sz="788" b="1" dirty="0">
                <a:latin typeface="Times New Roman" pitchFamily="18" charset="0"/>
                <a:cs typeface="Arial" charset="0"/>
              </a:rPr>
              <a:t> ≥ </a:t>
            </a:r>
            <a:r>
              <a:rPr lang="en-US" altLang="ja-JP" sz="788" b="1" dirty="0">
                <a:latin typeface="Times New Roman" pitchFamily="18" charset="0"/>
                <a:cs typeface="Arial" charset="0"/>
              </a:rPr>
              <a:t>30</a:t>
            </a:r>
            <a:endParaRPr lang="ja-JP" altLang="en-US" sz="788" b="1" dirty="0">
              <a:latin typeface="Times New Roman" pitchFamily="18" charset="0"/>
              <a:cs typeface="Arial" charset="0"/>
            </a:endParaRPr>
          </a:p>
        </p:txBody>
      </p:sp>
      <p:sp>
        <p:nvSpPr>
          <p:cNvPr id="60" name="テキスト ボックス 6">
            <a:extLst>
              <a:ext uri="{FF2B5EF4-FFF2-40B4-BE49-F238E27FC236}">
                <a16:creationId xmlns:a16="http://schemas.microsoft.com/office/drawing/2014/main" id="{6FF8FA60-18C7-874E-8F56-2C3A56231A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88372" y="3515491"/>
            <a:ext cx="983135" cy="36946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1013" b="1" i="1" dirty="0">
                <a:latin typeface="Times New Roman" pitchFamily="18" charset="0"/>
                <a:cs typeface="Arial" charset="0"/>
              </a:rPr>
              <a:t>P</a:t>
            </a:r>
            <a:r>
              <a:rPr lang="en-US" altLang="ja-JP" sz="1013" b="1" dirty="0">
                <a:latin typeface="Times New Roman" pitchFamily="18" charset="0"/>
                <a:cs typeface="Arial" charset="0"/>
              </a:rPr>
              <a:t> = 0.464</a:t>
            </a:r>
          </a:p>
          <a:p>
            <a:r>
              <a:rPr lang="en-US" altLang="ja-JP" sz="788" b="1" dirty="0">
                <a:latin typeface="Times New Roman" pitchFamily="18" charset="0"/>
                <a:cs typeface="Arial" charset="0"/>
              </a:rPr>
              <a:t>Log rank test</a:t>
            </a:r>
            <a:endParaRPr lang="ja-JP" altLang="en-US" sz="788" b="1" dirty="0">
              <a:latin typeface="Times New Roman" pitchFamily="18" charset="0"/>
              <a:cs typeface="Arial" charset="0"/>
            </a:endParaRPr>
          </a:p>
        </p:txBody>
      </p:sp>
      <p:sp>
        <p:nvSpPr>
          <p:cNvPr id="61" name="テキスト ボックス 6">
            <a:extLst>
              <a:ext uri="{FF2B5EF4-FFF2-40B4-BE49-F238E27FC236}">
                <a16:creationId xmlns:a16="http://schemas.microsoft.com/office/drawing/2014/main" id="{5FF7EB0C-4869-D3B6-F095-F3D9698E89B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88372" y="5786255"/>
            <a:ext cx="983135" cy="36946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1013" b="1" i="1" dirty="0">
                <a:latin typeface="Times New Roman" pitchFamily="18" charset="0"/>
                <a:cs typeface="Arial" charset="0"/>
              </a:rPr>
              <a:t>P</a:t>
            </a:r>
            <a:r>
              <a:rPr lang="en-US" altLang="ja-JP" sz="1013" b="1" dirty="0">
                <a:latin typeface="Times New Roman" pitchFamily="18" charset="0"/>
                <a:cs typeface="Arial" charset="0"/>
              </a:rPr>
              <a:t> = 0.997</a:t>
            </a:r>
          </a:p>
          <a:p>
            <a:r>
              <a:rPr lang="en-US" altLang="ja-JP" sz="788" b="1" dirty="0">
                <a:latin typeface="Times New Roman" pitchFamily="18" charset="0"/>
                <a:cs typeface="Arial" charset="0"/>
              </a:rPr>
              <a:t>Log rank test</a:t>
            </a:r>
            <a:endParaRPr lang="ja-JP" altLang="en-US" sz="788" b="1" dirty="0">
              <a:latin typeface="Times New Roman" pitchFamily="18" charset="0"/>
              <a:cs typeface="Arial" charset="0"/>
            </a:endParaRPr>
          </a:p>
        </p:txBody>
      </p:sp>
      <p:sp>
        <p:nvSpPr>
          <p:cNvPr id="64" name="テキスト ボックス 9">
            <a:extLst>
              <a:ext uri="{FF2B5EF4-FFF2-40B4-BE49-F238E27FC236}">
                <a16:creationId xmlns:a16="http://schemas.microsoft.com/office/drawing/2014/main" id="{5BD487ED-18CF-EF4B-C5EC-9AF398B5B74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98799" y="2943353"/>
            <a:ext cx="581140" cy="21358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788" b="1" dirty="0">
                <a:latin typeface="Times New Roman" pitchFamily="18" charset="0"/>
                <a:cs typeface="Arial" charset="0"/>
              </a:rPr>
              <a:t>n = 109 </a:t>
            </a:r>
            <a:endParaRPr lang="ja-JP" altLang="en-US" sz="788" b="1" dirty="0">
              <a:latin typeface="Times New Roman" pitchFamily="18" charset="0"/>
              <a:cs typeface="Arial" charset="0"/>
            </a:endParaRPr>
          </a:p>
        </p:txBody>
      </p:sp>
      <p:sp>
        <p:nvSpPr>
          <p:cNvPr id="65" name="テキスト ボックス 7">
            <a:extLst>
              <a:ext uri="{FF2B5EF4-FFF2-40B4-BE49-F238E27FC236}">
                <a16:creationId xmlns:a16="http://schemas.microsoft.com/office/drawing/2014/main" id="{418B0A1F-D37A-1E37-0C84-DE3AD042F97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31125" y="2817984"/>
            <a:ext cx="1528185" cy="21358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788" b="1" dirty="0">
                <a:latin typeface="Times New Roman" pitchFamily="18" charset="0"/>
                <a:cs typeface="Arial" charset="0"/>
              </a:rPr>
              <a:t>ALBI score </a:t>
            </a:r>
            <a:r>
              <a:rPr lang="ja-JP" altLang="en-US" sz="788" b="1" dirty="0">
                <a:latin typeface="Times New Roman" pitchFamily="18" charset="0"/>
                <a:cs typeface="Arial" charset="0"/>
              </a:rPr>
              <a:t>≥ </a:t>
            </a:r>
            <a:r>
              <a:rPr lang="en-US" altLang="ja-JP" sz="788" b="1" dirty="0">
                <a:latin typeface="Times New Roman" pitchFamily="18" charset="0"/>
                <a:cs typeface="Arial" charset="0"/>
              </a:rPr>
              <a:t>-2.6</a:t>
            </a:r>
            <a:endParaRPr lang="ja-JP" altLang="en-US" sz="788" b="1" dirty="0">
              <a:latin typeface="Times New Roman" pitchFamily="18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060724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524</TotalTime>
  <Words>130</Words>
  <Application>Microsoft Office PowerPoint</Application>
  <PresentationFormat>画面に合わせる (4:3)</PresentationFormat>
  <Paragraphs>3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住吉 秀太郎</dc:creator>
  <cp:lastModifiedBy>住吉 秀太郎</cp:lastModifiedBy>
  <cp:revision>9</cp:revision>
  <dcterms:created xsi:type="dcterms:W3CDTF">2021-06-28T07:36:12Z</dcterms:created>
  <dcterms:modified xsi:type="dcterms:W3CDTF">2023-03-18T13:41:47Z</dcterms:modified>
</cp:coreProperties>
</file>